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59" r:id="rId3"/>
    <p:sldId id="257" r:id="rId4"/>
    <p:sldId id="263" r:id="rId5"/>
    <p:sldId id="268" r:id="rId6"/>
  </p:sldIdLst>
  <p:sldSz cx="12192000" cy="6858000"/>
  <p:notesSz cx="9939338" cy="68072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234F4C3-A225-453B-A7BC-82B630B30983}" v="1" dt="2024-10-01T01:00:05.68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54" autoAdjust="0"/>
    <p:restoredTop sz="94660"/>
  </p:normalViewPr>
  <p:slideViewPr>
    <p:cSldViewPr snapToGrid="0">
      <p:cViewPr varScale="1">
        <p:scale>
          <a:sx n="94" d="100"/>
          <a:sy n="94" d="100"/>
        </p:scale>
        <p:origin x="1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stkyotouac-my.sharepoint.com/personal/teraishi_masayoshi_5e_ms_c_kyoto-u_ac_jp/Documents/&#30740;&#31350;&#38306;&#20418;/&#26681;&#31890;/&#22303;&#12418;&#12392;&#12487;&#12540;&#12479;/&#35542;&#25991;&#12395;&#12377;&#12427;/&#26681;&#31890;&#33740;QT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stkyotouac-my.sharepoint.com/personal/teraishi_masayoshi_5e_ms_c_kyoto-u_ac_jp/Documents/&#30740;&#31350;&#38306;&#20418;/&#22303;&#12418;&#12392;&#12487;&#12540;&#12479;/&#21513;&#24029;&#8592;&#22303;&#26412;20210428/PT&#35242;&#21644;&#24615;&#26681;&#31890;&#33740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stkyotouac-my.sharepoint.com/personal/teraishi_masayoshi_5e_ms_c_kyoto-u_ac_jp/Documents/&#30740;&#31350;&#38306;&#20418;/&#22303;&#12418;&#12392;&#12487;&#12540;&#12479;/&#21513;&#24029;&#8592;&#22303;&#26412;20210428/PT&#35242;&#21644;&#24615;&#26681;&#31890;&#33740;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8504632704044528E-2"/>
          <c:y val="8.7083679238540615E-2"/>
          <c:w val="0.95025038737627676"/>
          <c:h val="0.76561059468631609"/>
        </c:manualLayout>
      </c:layout>
      <c:lineChart>
        <c:grouping val="stacked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LR!$N$2918:$N$3042</c:f>
              <c:numCache>
                <c:formatCode>General</c:formatCode>
                <c:ptCount val="125"/>
                <c:pt idx="0">
                  <c:v>1.01</c:v>
                </c:pt>
                <c:pt idx="1">
                  <c:v>2.0099999999999998</c:v>
                </c:pt>
                <c:pt idx="2">
                  <c:v>3.01</c:v>
                </c:pt>
                <c:pt idx="3">
                  <c:v>4.01</c:v>
                </c:pt>
                <c:pt idx="4">
                  <c:v>5.01</c:v>
                </c:pt>
                <c:pt idx="5">
                  <c:v>6.01</c:v>
                </c:pt>
                <c:pt idx="6">
                  <c:v>7.01</c:v>
                </c:pt>
                <c:pt idx="7">
                  <c:v>8.01</c:v>
                </c:pt>
                <c:pt idx="8">
                  <c:v>9.01</c:v>
                </c:pt>
                <c:pt idx="9">
                  <c:v>10.01</c:v>
                </c:pt>
                <c:pt idx="10">
                  <c:v>10.14</c:v>
                </c:pt>
                <c:pt idx="11">
                  <c:v>10.18</c:v>
                </c:pt>
                <c:pt idx="12">
                  <c:v>10.220000000000001</c:v>
                </c:pt>
                <c:pt idx="13">
                  <c:v>10.26</c:v>
                </c:pt>
                <c:pt idx="14">
                  <c:v>10.299999999999999</c:v>
                </c:pt>
                <c:pt idx="15">
                  <c:v>10.34</c:v>
                </c:pt>
                <c:pt idx="16">
                  <c:v>11.110000000000001</c:v>
                </c:pt>
                <c:pt idx="17">
                  <c:v>11.87</c:v>
                </c:pt>
                <c:pt idx="18">
                  <c:v>12.870000000000001</c:v>
                </c:pt>
                <c:pt idx="19">
                  <c:v>12.889999999999999</c:v>
                </c:pt>
                <c:pt idx="20">
                  <c:v>13.389999999999999</c:v>
                </c:pt>
                <c:pt idx="21">
                  <c:v>13.639999999999999</c:v>
                </c:pt>
                <c:pt idx="22">
                  <c:v>13.68</c:v>
                </c:pt>
                <c:pt idx="23">
                  <c:v>13.719999999999999</c:v>
                </c:pt>
                <c:pt idx="24">
                  <c:v>13.969999999999999</c:v>
                </c:pt>
                <c:pt idx="25">
                  <c:v>14.35</c:v>
                </c:pt>
                <c:pt idx="26">
                  <c:v>14.729999999999999</c:v>
                </c:pt>
                <c:pt idx="27">
                  <c:v>15.229999999999999</c:v>
                </c:pt>
                <c:pt idx="28">
                  <c:v>16.23</c:v>
                </c:pt>
                <c:pt idx="29">
                  <c:v>17.03</c:v>
                </c:pt>
                <c:pt idx="30">
                  <c:v>18.029999999999998</c:v>
                </c:pt>
                <c:pt idx="31">
                  <c:v>18.05</c:v>
                </c:pt>
                <c:pt idx="32">
                  <c:v>18.09</c:v>
                </c:pt>
                <c:pt idx="33">
                  <c:v>19.09</c:v>
                </c:pt>
                <c:pt idx="34">
                  <c:v>19.63</c:v>
                </c:pt>
                <c:pt idx="35">
                  <c:v>20.39</c:v>
                </c:pt>
                <c:pt idx="36">
                  <c:v>20.64</c:v>
                </c:pt>
                <c:pt idx="37">
                  <c:v>20.68</c:v>
                </c:pt>
                <c:pt idx="38">
                  <c:v>20.72</c:v>
                </c:pt>
                <c:pt idx="39">
                  <c:v>20.76</c:v>
                </c:pt>
                <c:pt idx="40">
                  <c:v>20.8</c:v>
                </c:pt>
                <c:pt idx="41">
                  <c:v>20.84</c:v>
                </c:pt>
                <c:pt idx="42">
                  <c:v>20.880000000000003</c:v>
                </c:pt>
                <c:pt idx="43">
                  <c:v>20.919999999999998</c:v>
                </c:pt>
                <c:pt idx="44">
                  <c:v>20.96</c:v>
                </c:pt>
                <c:pt idx="45">
                  <c:v>21</c:v>
                </c:pt>
                <c:pt idx="46">
                  <c:v>21.04</c:v>
                </c:pt>
                <c:pt idx="47">
                  <c:v>21.08</c:v>
                </c:pt>
                <c:pt idx="48">
                  <c:v>21.34</c:v>
                </c:pt>
                <c:pt idx="49">
                  <c:v>21.6</c:v>
                </c:pt>
                <c:pt idx="50">
                  <c:v>21.64</c:v>
                </c:pt>
                <c:pt idx="51">
                  <c:v>22.41</c:v>
                </c:pt>
                <c:pt idx="52">
                  <c:v>22.67</c:v>
                </c:pt>
                <c:pt idx="53">
                  <c:v>22.71</c:v>
                </c:pt>
                <c:pt idx="54">
                  <c:v>22.75</c:v>
                </c:pt>
                <c:pt idx="55">
                  <c:v>22.79</c:v>
                </c:pt>
                <c:pt idx="56">
                  <c:v>23.05</c:v>
                </c:pt>
                <c:pt idx="57">
                  <c:v>23.31</c:v>
                </c:pt>
                <c:pt idx="58">
                  <c:v>23.35</c:v>
                </c:pt>
                <c:pt idx="59">
                  <c:v>23.61</c:v>
                </c:pt>
                <c:pt idx="60">
                  <c:v>23.65</c:v>
                </c:pt>
                <c:pt idx="61">
                  <c:v>23.69</c:v>
                </c:pt>
                <c:pt idx="62">
                  <c:v>24.69</c:v>
                </c:pt>
                <c:pt idx="63">
                  <c:v>25.259999999999998</c:v>
                </c:pt>
                <c:pt idx="64">
                  <c:v>26.26</c:v>
                </c:pt>
                <c:pt idx="65">
                  <c:v>27.26</c:v>
                </c:pt>
                <c:pt idx="66">
                  <c:v>28.26</c:v>
                </c:pt>
                <c:pt idx="67">
                  <c:v>29.26</c:v>
                </c:pt>
                <c:pt idx="68">
                  <c:v>29.59</c:v>
                </c:pt>
                <c:pt idx="69">
                  <c:v>30.4</c:v>
                </c:pt>
                <c:pt idx="70">
                  <c:v>31.4</c:v>
                </c:pt>
                <c:pt idx="71">
                  <c:v>32.4</c:v>
                </c:pt>
                <c:pt idx="72">
                  <c:v>33.4</c:v>
                </c:pt>
                <c:pt idx="73">
                  <c:v>34.4</c:v>
                </c:pt>
                <c:pt idx="74">
                  <c:v>35.4</c:v>
                </c:pt>
                <c:pt idx="75">
                  <c:v>36.4</c:v>
                </c:pt>
                <c:pt idx="76">
                  <c:v>37.4</c:v>
                </c:pt>
                <c:pt idx="77">
                  <c:v>38.4</c:v>
                </c:pt>
                <c:pt idx="78">
                  <c:v>39.4</c:v>
                </c:pt>
                <c:pt idx="79">
                  <c:v>40.400000000000006</c:v>
                </c:pt>
                <c:pt idx="80">
                  <c:v>41.4</c:v>
                </c:pt>
                <c:pt idx="81">
                  <c:v>41.74</c:v>
                </c:pt>
                <c:pt idx="82">
                  <c:v>41.78</c:v>
                </c:pt>
                <c:pt idx="83">
                  <c:v>42.78</c:v>
                </c:pt>
                <c:pt idx="84">
                  <c:v>43.78</c:v>
                </c:pt>
                <c:pt idx="85">
                  <c:v>44.78</c:v>
                </c:pt>
                <c:pt idx="86">
                  <c:v>45.78</c:v>
                </c:pt>
                <c:pt idx="87">
                  <c:v>46.78</c:v>
                </c:pt>
                <c:pt idx="88">
                  <c:v>47.78</c:v>
                </c:pt>
                <c:pt idx="89">
                  <c:v>48.78</c:v>
                </c:pt>
                <c:pt idx="90">
                  <c:v>49.220000000000006</c:v>
                </c:pt>
                <c:pt idx="91">
                  <c:v>49.26</c:v>
                </c:pt>
                <c:pt idx="92">
                  <c:v>50.019999999999996</c:v>
                </c:pt>
                <c:pt idx="93">
                  <c:v>51.019999999999996</c:v>
                </c:pt>
                <c:pt idx="94">
                  <c:v>52.019999999999996</c:v>
                </c:pt>
                <c:pt idx="95">
                  <c:v>52.93</c:v>
                </c:pt>
                <c:pt idx="96">
                  <c:v>53.93</c:v>
                </c:pt>
                <c:pt idx="97">
                  <c:v>54.93</c:v>
                </c:pt>
                <c:pt idx="98">
                  <c:v>55.93</c:v>
                </c:pt>
                <c:pt idx="99">
                  <c:v>56.93</c:v>
                </c:pt>
                <c:pt idx="100">
                  <c:v>57.930000000000007</c:v>
                </c:pt>
                <c:pt idx="101">
                  <c:v>58.930000000000007</c:v>
                </c:pt>
                <c:pt idx="102">
                  <c:v>59.930000000000007</c:v>
                </c:pt>
                <c:pt idx="103">
                  <c:v>60.929999999999993</c:v>
                </c:pt>
                <c:pt idx="104">
                  <c:v>61.929999999999993</c:v>
                </c:pt>
                <c:pt idx="105">
                  <c:v>62.93</c:v>
                </c:pt>
                <c:pt idx="106">
                  <c:v>63.93</c:v>
                </c:pt>
                <c:pt idx="107">
                  <c:v>64.929999999999993</c:v>
                </c:pt>
                <c:pt idx="108">
                  <c:v>65.930000000000007</c:v>
                </c:pt>
                <c:pt idx="109">
                  <c:v>66.930000000000007</c:v>
                </c:pt>
                <c:pt idx="110">
                  <c:v>67.930000000000007</c:v>
                </c:pt>
                <c:pt idx="111">
                  <c:v>68.930000000000007</c:v>
                </c:pt>
                <c:pt idx="112">
                  <c:v>69.930000000000007</c:v>
                </c:pt>
                <c:pt idx="113">
                  <c:v>70.930000000000007</c:v>
                </c:pt>
                <c:pt idx="114">
                  <c:v>71.930000000000007</c:v>
                </c:pt>
                <c:pt idx="115">
                  <c:v>72.009999999999991</c:v>
                </c:pt>
                <c:pt idx="116">
                  <c:v>73.009999999999991</c:v>
                </c:pt>
                <c:pt idx="117">
                  <c:v>74.009999999999991</c:v>
                </c:pt>
                <c:pt idx="118">
                  <c:v>74.709999999999994</c:v>
                </c:pt>
                <c:pt idx="119">
                  <c:v>75.709999999999994</c:v>
                </c:pt>
                <c:pt idx="120">
                  <c:v>76.570000000000007</c:v>
                </c:pt>
                <c:pt idx="121">
                  <c:v>77.569999999999993</c:v>
                </c:pt>
                <c:pt idx="122">
                  <c:v>78.569999999999993</c:v>
                </c:pt>
                <c:pt idx="123">
                  <c:v>79.569999999999993</c:v>
                </c:pt>
                <c:pt idx="124">
                  <c:v>80.569999999999993</c:v>
                </c:pt>
              </c:numCache>
            </c:numRef>
          </c:cat>
          <c:val>
            <c:numRef>
              <c:f>LR!$O$2918:$O$3042</c:f>
              <c:numCache>
                <c:formatCode>General</c:formatCode>
                <c:ptCount val="125"/>
                <c:pt idx="0">
                  <c:v>0.23239857741986336</c:v>
                </c:pt>
                <c:pt idx="1">
                  <c:v>0.23455094087217584</c:v>
                </c:pt>
                <c:pt idx="2">
                  <c:v>0.23449165967539606</c:v>
                </c:pt>
                <c:pt idx="3">
                  <c:v>0.23203355290782365</c:v>
                </c:pt>
                <c:pt idx="4">
                  <c:v>0.22712515667335309</c:v>
                </c:pt>
                <c:pt idx="5">
                  <c:v>0.21986918161695451</c:v>
                </c:pt>
                <c:pt idx="6">
                  <c:v>0.21052577013328796</c:v>
                </c:pt>
                <c:pt idx="7">
                  <c:v>0.19949099878984919</c:v>
                </c:pt>
                <c:pt idx="8">
                  <c:v>0.1872523631425746</c:v>
                </c:pt>
                <c:pt idx="9">
                  <c:v>0.17433101656974812</c:v>
                </c:pt>
                <c:pt idx="10">
                  <c:v>0.17280859726343625</c:v>
                </c:pt>
                <c:pt idx="11">
                  <c:v>0.17280859726343625</c:v>
                </c:pt>
                <c:pt idx="12">
                  <c:v>0.17280859726343625</c:v>
                </c:pt>
                <c:pt idx="13">
                  <c:v>0.17280859726343625</c:v>
                </c:pt>
                <c:pt idx="14">
                  <c:v>0.17280859726343625</c:v>
                </c:pt>
                <c:pt idx="15">
                  <c:v>0.21400446893333303</c:v>
                </c:pt>
                <c:pt idx="16">
                  <c:v>0.14095613707720606</c:v>
                </c:pt>
                <c:pt idx="17">
                  <c:v>6.0454009028173605E-2</c:v>
                </c:pt>
                <c:pt idx="18">
                  <c:v>0.16908430493387491</c:v>
                </c:pt>
                <c:pt idx="19">
                  <c:v>0.17037785104822376</c:v>
                </c:pt>
                <c:pt idx="20">
                  <c:v>0.14684321592664559</c:v>
                </c:pt>
                <c:pt idx="21">
                  <c:v>0.14684321592664559</c:v>
                </c:pt>
                <c:pt idx="22">
                  <c:v>0.14684321592664559</c:v>
                </c:pt>
                <c:pt idx="23">
                  <c:v>0.14684321592664559</c:v>
                </c:pt>
                <c:pt idx="24">
                  <c:v>0.14684321592664559</c:v>
                </c:pt>
                <c:pt idx="25">
                  <c:v>0.20544409040053802</c:v>
                </c:pt>
                <c:pt idx="26">
                  <c:v>0.20544409040053802</c:v>
                </c:pt>
                <c:pt idx="27">
                  <c:v>0.20431644477827621</c:v>
                </c:pt>
                <c:pt idx="28">
                  <c:v>9.4692700245221223E-2</c:v>
                </c:pt>
                <c:pt idx="29">
                  <c:v>3.0106379221738169E-2</c:v>
                </c:pt>
                <c:pt idx="30">
                  <c:v>4.8777784734963725E-3</c:v>
                </c:pt>
                <c:pt idx="31">
                  <c:v>4.7318555275768798E-3</c:v>
                </c:pt>
                <c:pt idx="32">
                  <c:v>4.7077521838312496E-3</c:v>
                </c:pt>
                <c:pt idx="33">
                  <c:v>2.5362797743149904E-3</c:v>
                </c:pt>
                <c:pt idx="34">
                  <c:v>1.6290386016190974E-3</c:v>
                </c:pt>
                <c:pt idx="35">
                  <c:v>1.6290386016190974E-3</c:v>
                </c:pt>
                <c:pt idx="36">
                  <c:v>1.6290386016190974E-3</c:v>
                </c:pt>
                <c:pt idx="37">
                  <c:v>1.6290386016190974E-3</c:v>
                </c:pt>
                <c:pt idx="38">
                  <c:v>1.6290386016190974E-3</c:v>
                </c:pt>
                <c:pt idx="39">
                  <c:v>1.6290386016190974E-3</c:v>
                </c:pt>
                <c:pt idx="40">
                  <c:v>1.6290386016190974E-3</c:v>
                </c:pt>
                <c:pt idx="41">
                  <c:v>1.6290386016190974E-3</c:v>
                </c:pt>
                <c:pt idx="42">
                  <c:v>1.6290386016190974E-3</c:v>
                </c:pt>
                <c:pt idx="43">
                  <c:v>1.6290386016190974E-3</c:v>
                </c:pt>
                <c:pt idx="44">
                  <c:v>1.6290386016190974E-3</c:v>
                </c:pt>
                <c:pt idx="45">
                  <c:v>1.6290386016190974E-3</c:v>
                </c:pt>
                <c:pt idx="46">
                  <c:v>1.6290386016190974E-3</c:v>
                </c:pt>
                <c:pt idx="47">
                  <c:v>1.6290386016190974E-3</c:v>
                </c:pt>
                <c:pt idx="48">
                  <c:v>1.6290386016190974E-3</c:v>
                </c:pt>
                <c:pt idx="49">
                  <c:v>1.6290386016190974E-3</c:v>
                </c:pt>
                <c:pt idx="50">
                  <c:v>1.5200306866613813E-3</c:v>
                </c:pt>
                <c:pt idx="51">
                  <c:v>4.5314286241785297E-3</c:v>
                </c:pt>
                <c:pt idx="52">
                  <c:v>4.5316457714194803E-3</c:v>
                </c:pt>
                <c:pt idx="53">
                  <c:v>4.5316457714194803E-3</c:v>
                </c:pt>
                <c:pt idx="54">
                  <c:v>4.5316457714194803E-3</c:v>
                </c:pt>
                <c:pt idx="55">
                  <c:v>4.5314286241785297E-3</c:v>
                </c:pt>
                <c:pt idx="56">
                  <c:v>5.3146787222910436E-3</c:v>
                </c:pt>
                <c:pt idx="57">
                  <c:v>4.4053963655302057E-2</c:v>
                </c:pt>
                <c:pt idx="58">
                  <c:v>4.19098517981457E-2</c:v>
                </c:pt>
                <c:pt idx="59">
                  <c:v>4.5316457714194803E-3</c:v>
                </c:pt>
                <c:pt idx="60">
                  <c:v>4.5316457714194803E-3</c:v>
                </c:pt>
                <c:pt idx="61">
                  <c:v>4.5650864465260309E-3</c:v>
                </c:pt>
                <c:pt idx="62">
                  <c:v>8.5412695755912524E-3</c:v>
                </c:pt>
                <c:pt idx="63">
                  <c:v>4.712637996752661E-2</c:v>
                </c:pt>
                <c:pt idx="64">
                  <c:v>1.0296905018685149E-2</c:v>
                </c:pt>
                <c:pt idx="65">
                  <c:v>7.2700896270604348E-4</c:v>
                </c:pt>
                <c:pt idx="66">
                  <c:v>2.4153939052772203E-2</c:v>
                </c:pt>
                <c:pt idx="67">
                  <c:v>7.3104572991533417E-2</c:v>
                </c:pt>
                <c:pt idx="68">
                  <c:v>0.17238863449943581</c:v>
                </c:pt>
                <c:pt idx="69">
                  <c:v>0.14245163012563991</c:v>
                </c:pt>
                <c:pt idx="70">
                  <c:v>0.16120576873766804</c:v>
                </c:pt>
                <c:pt idx="71">
                  <c:v>0.1804287282429107</c:v>
                </c:pt>
                <c:pt idx="72">
                  <c:v>0.19883456268045244</c:v>
                </c:pt>
                <c:pt idx="73">
                  <c:v>0.21489042967641564</c:v>
                </c:pt>
                <c:pt idx="74">
                  <c:v>0.22714426563055684</c:v>
                </c:pt>
                <c:pt idx="75">
                  <c:v>0.23457070127110247</c:v>
                </c:pt>
                <c:pt idx="76">
                  <c:v>0.23679363757672425</c:v>
                </c:pt>
                <c:pt idx="77">
                  <c:v>0.23410948053132119</c:v>
                </c:pt>
                <c:pt idx="78">
                  <c:v>0.2273416524725819</c:v>
                </c:pt>
                <c:pt idx="79">
                  <c:v>0.21759934150728716</c:v>
                </c:pt>
                <c:pt idx="80">
                  <c:v>0.20602843362593884</c:v>
                </c:pt>
                <c:pt idx="81">
                  <c:v>0.27791220482884221</c:v>
                </c:pt>
                <c:pt idx="82">
                  <c:v>0.42103438563454076</c:v>
                </c:pt>
                <c:pt idx="83">
                  <c:v>0.38692467987861839</c:v>
                </c:pt>
                <c:pt idx="84">
                  <c:v>0.35011149097284833</c:v>
                </c:pt>
                <c:pt idx="85">
                  <c:v>0.31131205625409369</c:v>
                </c:pt>
                <c:pt idx="86">
                  <c:v>0.2714685776008437</c:v>
                </c:pt>
                <c:pt idx="87">
                  <c:v>0.23169350032849342</c:v>
                </c:pt>
                <c:pt idx="88">
                  <c:v>0.19317266551987972</c:v>
                </c:pt>
                <c:pt idx="89">
                  <c:v>0.15703523882795109</c:v>
                </c:pt>
                <c:pt idx="90">
                  <c:v>0.14761778013512003</c:v>
                </c:pt>
                <c:pt idx="91">
                  <c:v>0.1470851179530657</c:v>
                </c:pt>
                <c:pt idx="92">
                  <c:v>0.10812151992015166</c:v>
                </c:pt>
                <c:pt idx="93">
                  <c:v>0.11378667428933863</c:v>
                </c:pt>
                <c:pt idx="94">
                  <c:v>0.11751769818336948</c:v>
                </c:pt>
                <c:pt idx="95">
                  <c:v>1.031023568780717</c:v>
                </c:pt>
                <c:pt idx="96">
                  <c:v>1.2569487698005712</c:v>
                </c:pt>
                <c:pt idx="97">
                  <c:v>1.527649949051892</c:v>
                </c:pt>
                <c:pt idx="98">
                  <c:v>1.8487514372225666</c:v>
                </c:pt>
                <c:pt idx="99">
                  <c:v>2.2232396603174038</c:v>
                </c:pt>
                <c:pt idx="100">
                  <c:v>2.6486035276420377</c:v>
                </c:pt>
                <c:pt idx="101">
                  <c:v>3.1146210499759128</c:v>
                </c:pt>
                <c:pt idx="102">
                  <c:v>3.6044340012677489</c:v>
                </c:pt>
                <c:pt idx="103">
                  <c:v>4.0988769660311553</c:v>
                </c:pt>
                <c:pt idx="104">
                  <c:v>4.5805314783331976</c:v>
                </c:pt>
                <c:pt idx="105">
                  <c:v>5.0355363783422105</c:v>
                </c:pt>
                <c:pt idx="106">
                  <c:v>5.4540950682826619</c:v>
                </c:pt>
                <c:pt idx="107">
                  <c:v>5.8306685563323573</c:v>
                </c:pt>
                <c:pt idx="108">
                  <c:v>6.1637789383693802</c:v>
                </c:pt>
                <c:pt idx="109">
                  <c:v>6.4551616551434154</c:v>
                </c:pt>
                <c:pt idx="110">
                  <c:v>6.708521021437857</c:v>
                </c:pt>
                <c:pt idx="111">
                  <c:v>6.9283773913675955</c:v>
                </c:pt>
                <c:pt idx="112">
                  <c:v>7.1192910741398556</c:v>
                </c:pt>
                <c:pt idx="113">
                  <c:v>7.2854571373025818</c:v>
                </c:pt>
                <c:pt idx="114">
                  <c:v>7.4305570951788678</c:v>
                </c:pt>
                <c:pt idx="115">
                  <c:v>7.4868651119355514</c:v>
                </c:pt>
                <c:pt idx="116">
                  <c:v>10.096036220651461</c:v>
                </c:pt>
                <c:pt idx="117">
                  <c:v>11.151031759097032</c:v>
                </c:pt>
                <c:pt idx="118">
                  <c:v>11.759173019222711</c:v>
                </c:pt>
                <c:pt idx="119">
                  <c:v>14.893955973373741</c:v>
                </c:pt>
                <c:pt idx="120">
                  <c:v>14.987207033086282</c:v>
                </c:pt>
                <c:pt idx="121">
                  <c:v>15.128230920102666</c:v>
                </c:pt>
                <c:pt idx="122">
                  <c:v>14.658161430252633</c:v>
                </c:pt>
                <c:pt idx="123">
                  <c:v>13.650503121745555</c:v>
                </c:pt>
                <c:pt idx="124">
                  <c:v>11.4305495506254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76F-41AA-84F1-F9616B671A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60401551"/>
        <c:axId val="1560402031"/>
      </c:lineChart>
      <c:catAx>
        <c:axId val="156040155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560402031"/>
        <c:crosses val="autoZero"/>
        <c:auto val="1"/>
        <c:lblAlgn val="ctr"/>
        <c:lblOffset val="100"/>
        <c:tickLblSkip val="5"/>
        <c:tickMarkSkip val="5"/>
        <c:noMultiLvlLbl val="0"/>
      </c:catAx>
      <c:valAx>
        <c:axId val="156040203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60401551"/>
        <c:crosses val="autoZero"/>
        <c:crossBetween val="between"/>
      </c:valAx>
      <c:spPr>
        <a:noFill/>
        <a:ln w="15875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0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i="1" dirty="0"/>
              <a:t>B. japonicum</a:t>
            </a:r>
            <a:endParaRPr lang="ja-JP" sz="1400" i="1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Sheet2 (寺石改)'!$E$2</c:f>
              <c:strCache>
                <c:ptCount val="1"/>
                <c:pt idx="0">
                  <c:v>Pekingホモ型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Sheet2 (寺石改)'!$D$3:$D$12</c:f>
              <c:strCache>
                <c:ptCount val="10"/>
                <c:pt idx="0">
                  <c:v>0~10</c:v>
                </c:pt>
                <c:pt idx="1">
                  <c:v>11~20</c:v>
                </c:pt>
                <c:pt idx="2">
                  <c:v>21~30</c:v>
                </c:pt>
                <c:pt idx="3">
                  <c:v>31~40</c:v>
                </c:pt>
                <c:pt idx="4">
                  <c:v>41~50</c:v>
                </c:pt>
                <c:pt idx="5">
                  <c:v>51~60</c:v>
                </c:pt>
                <c:pt idx="6">
                  <c:v>61~70</c:v>
                </c:pt>
                <c:pt idx="7">
                  <c:v>71~80</c:v>
                </c:pt>
                <c:pt idx="8">
                  <c:v>81~90</c:v>
                </c:pt>
                <c:pt idx="9">
                  <c:v>91~100</c:v>
                </c:pt>
              </c:strCache>
            </c:strRef>
          </c:cat>
          <c:val>
            <c:numRef>
              <c:f>'Sheet2 (寺石改)'!$E$3:$E$12</c:f>
              <c:numCache>
                <c:formatCode>General</c:formatCode>
                <c:ptCount val="10"/>
                <c:pt idx="0">
                  <c:v>3</c:v>
                </c:pt>
                <c:pt idx="1">
                  <c:v>9</c:v>
                </c:pt>
                <c:pt idx="2">
                  <c:v>6</c:v>
                </c:pt>
                <c:pt idx="3">
                  <c:v>8</c:v>
                </c:pt>
                <c:pt idx="4">
                  <c:v>5</c:v>
                </c:pt>
                <c:pt idx="5">
                  <c:v>5</c:v>
                </c:pt>
                <c:pt idx="6">
                  <c:v>1</c:v>
                </c:pt>
                <c:pt idx="7">
                  <c:v>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2D-434A-B655-9115E6EAF7B6}"/>
            </c:ext>
          </c:extLst>
        </c:ser>
        <c:ser>
          <c:idx val="1"/>
          <c:order val="1"/>
          <c:tx>
            <c:strRef>
              <c:f>'Sheet2 (寺石改)'!$F$2</c:f>
              <c:strCache>
                <c:ptCount val="1"/>
                <c:pt idx="0">
                  <c:v>タマホマレホモ型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heet2 (寺石改)'!$D$3:$D$12</c:f>
              <c:strCache>
                <c:ptCount val="10"/>
                <c:pt idx="0">
                  <c:v>0~10</c:v>
                </c:pt>
                <c:pt idx="1">
                  <c:v>11~20</c:v>
                </c:pt>
                <c:pt idx="2">
                  <c:v>21~30</c:v>
                </c:pt>
                <c:pt idx="3">
                  <c:v>31~40</c:v>
                </c:pt>
                <c:pt idx="4">
                  <c:v>41~50</c:v>
                </c:pt>
                <c:pt idx="5">
                  <c:v>51~60</c:v>
                </c:pt>
                <c:pt idx="6">
                  <c:v>61~70</c:v>
                </c:pt>
                <c:pt idx="7">
                  <c:v>71~80</c:v>
                </c:pt>
                <c:pt idx="8">
                  <c:v>81~90</c:v>
                </c:pt>
                <c:pt idx="9">
                  <c:v>91~100</c:v>
                </c:pt>
              </c:strCache>
            </c:strRef>
          </c:cat>
          <c:val>
            <c:numRef>
              <c:f>'Sheet2 (寺石改)'!$F$3:$F$12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4</c:v>
                </c:pt>
                <c:pt idx="5">
                  <c:v>8</c:v>
                </c:pt>
                <c:pt idx="6">
                  <c:v>8</c:v>
                </c:pt>
                <c:pt idx="7">
                  <c:v>13</c:v>
                </c:pt>
                <c:pt idx="8">
                  <c:v>12</c:v>
                </c:pt>
                <c:pt idx="9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82D-434A-B655-9115E6EAF7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172090688"/>
        <c:axId val="1172091648"/>
      </c:barChart>
      <c:catAx>
        <c:axId val="1172090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172091648"/>
        <c:crosses val="autoZero"/>
        <c:auto val="1"/>
        <c:lblAlgn val="ctr"/>
        <c:lblOffset val="100"/>
        <c:noMultiLvlLbl val="0"/>
      </c:catAx>
      <c:valAx>
        <c:axId val="11720916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accent1">
                <a:shade val="1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172090688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i="1" dirty="0"/>
              <a:t>B. elkanii</a:t>
            </a:r>
            <a:endParaRPr lang="ja-JP" altLang="en-US" i="1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Sheet2 (寺石改)'!$G$2</c:f>
              <c:strCache>
                <c:ptCount val="1"/>
                <c:pt idx="0">
                  <c:v>Pekingホモ型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Sheet2 (寺石改)'!$D$3:$D$12</c:f>
              <c:strCache>
                <c:ptCount val="10"/>
                <c:pt idx="0">
                  <c:v>0~10</c:v>
                </c:pt>
                <c:pt idx="1">
                  <c:v>11~20</c:v>
                </c:pt>
                <c:pt idx="2">
                  <c:v>21~30</c:v>
                </c:pt>
                <c:pt idx="3">
                  <c:v>31~40</c:v>
                </c:pt>
                <c:pt idx="4">
                  <c:v>41~50</c:v>
                </c:pt>
                <c:pt idx="5">
                  <c:v>51~60</c:v>
                </c:pt>
                <c:pt idx="6">
                  <c:v>61~70</c:v>
                </c:pt>
                <c:pt idx="7">
                  <c:v>71~80</c:v>
                </c:pt>
                <c:pt idx="8">
                  <c:v>81~90</c:v>
                </c:pt>
                <c:pt idx="9">
                  <c:v>91~100</c:v>
                </c:pt>
              </c:strCache>
            </c:strRef>
          </c:cat>
          <c:val>
            <c:numRef>
              <c:f>'Sheet2 (寺石改)'!$G$3:$G$12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1</c:v>
                </c:pt>
                <c:pt idx="4">
                  <c:v>3</c:v>
                </c:pt>
                <c:pt idx="5">
                  <c:v>7</c:v>
                </c:pt>
                <c:pt idx="6">
                  <c:v>11</c:v>
                </c:pt>
                <c:pt idx="7">
                  <c:v>3</c:v>
                </c:pt>
                <c:pt idx="8">
                  <c:v>9</c:v>
                </c:pt>
                <c:pt idx="9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A4-4652-B723-2B49CB2ED9FB}"/>
            </c:ext>
          </c:extLst>
        </c:ser>
        <c:ser>
          <c:idx val="1"/>
          <c:order val="1"/>
          <c:tx>
            <c:strRef>
              <c:f>'Sheet2 (寺石改)'!$H$2</c:f>
              <c:strCache>
                <c:ptCount val="1"/>
                <c:pt idx="0">
                  <c:v>タマホマレホモ型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heet2 (寺石改)'!$D$3:$D$12</c:f>
              <c:strCache>
                <c:ptCount val="10"/>
                <c:pt idx="0">
                  <c:v>0~10</c:v>
                </c:pt>
                <c:pt idx="1">
                  <c:v>11~20</c:v>
                </c:pt>
                <c:pt idx="2">
                  <c:v>21~30</c:v>
                </c:pt>
                <c:pt idx="3">
                  <c:v>31~40</c:v>
                </c:pt>
                <c:pt idx="4">
                  <c:v>41~50</c:v>
                </c:pt>
                <c:pt idx="5">
                  <c:v>51~60</c:v>
                </c:pt>
                <c:pt idx="6">
                  <c:v>61~70</c:v>
                </c:pt>
                <c:pt idx="7">
                  <c:v>71~80</c:v>
                </c:pt>
                <c:pt idx="8">
                  <c:v>81~90</c:v>
                </c:pt>
                <c:pt idx="9">
                  <c:v>91~100</c:v>
                </c:pt>
              </c:strCache>
            </c:strRef>
          </c:cat>
          <c:val>
            <c:numRef>
              <c:f>'Sheet2 (寺石改)'!$H$3:$H$12</c:f>
              <c:numCache>
                <c:formatCode>General</c:formatCode>
                <c:ptCount val="10"/>
                <c:pt idx="0">
                  <c:v>7</c:v>
                </c:pt>
                <c:pt idx="1">
                  <c:v>13</c:v>
                </c:pt>
                <c:pt idx="2">
                  <c:v>12</c:v>
                </c:pt>
                <c:pt idx="3">
                  <c:v>9</c:v>
                </c:pt>
                <c:pt idx="4">
                  <c:v>5</c:v>
                </c:pt>
                <c:pt idx="5">
                  <c:v>6</c:v>
                </c:pt>
                <c:pt idx="6">
                  <c:v>4</c:v>
                </c:pt>
                <c:pt idx="7">
                  <c:v>2</c:v>
                </c:pt>
                <c:pt idx="8">
                  <c:v>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FA4-4652-B723-2B49CB2ED9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172090688"/>
        <c:axId val="1172091648"/>
      </c:barChart>
      <c:catAx>
        <c:axId val="1172090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172091648"/>
        <c:crosses val="autoZero"/>
        <c:auto val="1"/>
        <c:lblAlgn val="ctr"/>
        <c:lblOffset val="100"/>
        <c:noMultiLvlLbl val="0"/>
      </c:catAx>
      <c:valAx>
        <c:axId val="11720916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172090688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</cdr:x>
      <cdr:y>0.66667</cdr:y>
    </cdr:from>
    <cdr:to>
      <cdr:x>1</cdr:x>
      <cdr:y>1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DEF53CAD-D34E-546B-B3F9-AF672F2F49A8}"/>
            </a:ext>
          </a:extLst>
        </cdr:cNvPr>
        <cdr:cNvSpPr txBox="1"/>
      </cdr:nvSpPr>
      <cdr:spPr>
        <a:xfrm xmlns:a="http://schemas.openxmlformats.org/drawingml/2006/main">
          <a:off x="4572000" y="263622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16F2D9-8716-BC6D-1416-AA37FE48BE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14A8025-C258-2AD6-F85F-3D51BDABC8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F679FC-2709-01CD-4F9E-DD9668B16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E57085C-EC99-94AB-9C99-1D386CC80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F48B34-CCDB-DC97-D08B-6A5129A00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7359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32A9BD-C87D-07C2-701D-9FEEE746E0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51C9F50-D055-508B-9CDB-10BFAC37B5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782DA3-46EB-AA63-A5FA-1A2FCAFD9D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172A86-5F74-CFFF-EBFB-DF5B832B6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EC38F7-7AA9-5C4D-3449-2B0B766BC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4031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E144DD9-A838-01D3-1A67-D8E88987A4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52ECE31-7900-7F30-65F9-C1E84A2EFE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338C71A-1BB2-1E8F-491B-2D1125012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2751B6-BE70-4342-68F2-F8A662A94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C2C093-C3B9-9030-DF09-9FB7994F3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0933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5C39C8-170A-626A-68B2-391FDC070D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59C3FC7-5254-CFA1-05A9-A404DB175E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71DF7FC-7746-A387-559B-7166C3026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09BFF5-AB2C-14DF-3256-D54E9423AF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07B8A6F-53F8-D6F2-79AB-91FD66A12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0104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27E3DB-778B-E30C-A162-A324DDB2C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31E9E36-EBE4-53A5-2A0E-4AAEAE4CB2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753BC8C-5CAA-3B3A-47E1-0A5BD9AAE0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D72BEEF-2C6F-279E-F3D8-5B0696A00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535F99-55A1-5908-00B7-08E06451F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666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7A0DE8-5354-1FD5-E328-D7C3246C96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EC0E455-47E3-EF19-0C84-635598E3837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273B412-2673-4926-6330-A04AA91EF1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C577E5E-0D73-BF0C-BFF4-867381476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58D844E-4774-D4BA-356D-CD530A836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EBBE75B-2D02-07E2-BCB4-C407A5BB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0755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319364-E9D9-58AF-31FB-ECCF0FCA3D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8865D75-D84C-4F17-5309-D0FABE0E1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29B4CBE-1F62-F2AE-66BF-7AB8BD58B3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F77F4D2-A521-516B-C1D5-AA19178606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EFC2C26-DEAD-5231-5689-D21B4A65FF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BC84A21-7BA6-F2F5-8DBF-507FD8983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D837413-CDF3-D47A-5815-27344CF67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494AB5D-58D3-E1C7-6D24-77A192F3C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614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D8117C-0AEC-D06C-85E3-AB8CC4DB66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F4D509C-BC45-B397-6181-EB46B0D9AF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A15A963-8E51-C8C4-13FA-58847CE8F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AD7A08F-881F-7919-57D5-53E1575D82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9413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3E70CB7-58ED-DE33-3D2E-381B279BE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B95F1F9-1125-0F3B-B7B0-4D4F5A097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7E9BDDC-B4BE-B1C6-A32F-D94F01307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3410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234D9C-651A-96DE-F456-A2A9EBFCC9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77B6435-9E2C-3323-1387-441307D655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D6D8510-34F4-93F1-17A9-2CB25E8B2B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00FBE68-818E-4E14-BA9D-C37E8D4405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D3588BD-D630-EA4B-A559-A40ECC301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70851FE-5980-BD49-F28D-444EEDAEE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381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3C084A-7836-53C0-3058-86427F6D71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1E41F0C-1850-B6EE-F1CF-B8F5FD3FC4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33E6219-354F-D88B-257B-BBE71BDA0D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2C995ED-0D6E-3ABD-0E65-6C391C2F0B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E2B43BD-CD6B-FB9E-9E0A-B5A0D3E32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9DFE85-A8D7-31E0-C9DA-AC4D076EF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2932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5E984A5-10C8-0B22-7583-2CF4D2548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154BB70-6464-C720-1FC6-8C6125595A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895065-1EEC-8C21-42CB-65838014FA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ED949-B6AE-4C3E-96A1-DD7C3BE6D06B}" type="datetimeFigureOut">
              <a:rPr kumimoji="1" lang="ja-JP" altLang="en-US" smtClean="0"/>
              <a:t>2024/10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0BC7BB-FFB7-CC48-97EE-4B7B8963AE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603400-22D6-33BA-0D7A-7050E4A17B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4811AA-5D85-46C1-B205-4A7541EE15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6839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E46B72F-F8FF-0776-B4F0-009E38634854}"/>
              </a:ext>
            </a:extLst>
          </p:cNvPr>
          <p:cNvSpPr txBox="1"/>
          <p:nvPr/>
        </p:nvSpPr>
        <p:spPr>
          <a:xfrm>
            <a:off x="2253779" y="5841113"/>
            <a:ext cx="48173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</a:t>
            </a:r>
            <a:r>
              <a:rPr lang="en-US" altLang="ja-JP" dirty="0"/>
              <a:t>1</a:t>
            </a:r>
            <a:r>
              <a:rPr kumimoji="1" lang="en-US" altLang="ja-JP" dirty="0"/>
              <a:t>  QTL location on Chromosome 18</a:t>
            </a:r>
            <a:endParaRPr kumimoji="1" lang="ja-JP" altLang="en-US" dirty="0"/>
          </a:p>
        </p:txBody>
      </p:sp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AFF0C65D-101A-969B-9462-0F57964CD0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1168000"/>
              </p:ext>
            </p:extLst>
          </p:nvPr>
        </p:nvGraphicFramePr>
        <p:xfrm>
          <a:off x="2032471" y="46620"/>
          <a:ext cx="7905750" cy="5862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6" name="テキスト ボックス 3">
            <a:extLst>
              <a:ext uri="{FF2B5EF4-FFF2-40B4-BE49-F238E27FC236}">
                <a16:creationId xmlns:a16="http://schemas.microsoft.com/office/drawing/2014/main" id="{8CC351B2-6131-6F4A-163A-7DF7E2940DBF}"/>
              </a:ext>
            </a:extLst>
          </p:cNvPr>
          <p:cNvSpPr txBox="1"/>
          <p:nvPr/>
        </p:nvSpPr>
        <p:spPr>
          <a:xfrm rot="16200000">
            <a:off x="1520046" y="2545768"/>
            <a:ext cx="556563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/>
              <a:t>LOD</a:t>
            </a:r>
            <a:endParaRPr kumimoji="1" lang="ja-JP" altLang="en-US" sz="1400" dirty="0"/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65EA8335-06C4-4903-3D93-DB38909651F8}"/>
              </a:ext>
            </a:extLst>
          </p:cNvPr>
          <p:cNvCxnSpPr/>
          <p:nvPr/>
        </p:nvCxnSpPr>
        <p:spPr>
          <a:xfrm flipH="1">
            <a:off x="9662281" y="830498"/>
            <a:ext cx="47625" cy="422910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0A5F0AC8-68A3-338B-F525-F32F66D9AA22}"/>
              </a:ext>
            </a:extLst>
          </p:cNvPr>
          <p:cNvGrpSpPr/>
          <p:nvPr/>
        </p:nvGrpSpPr>
        <p:grpSpPr>
          <a:xfrm>
            <a:off x="2173524" y="5130784"/>
            <a:ext cx="7844952" cy="787395"/>
            <a:chOff x="2173524" y="5130784"/>
            <a:chExt cx="7844952" cy="787395"/>
          </a:xfrm>
        </p:grpSpPr>
        <p:sp>
          <p:nvSpPr>
            <p:cNvPr id="20" name="テキスト ボックス 4">
              <a:extLst>
                <a:ext uri="{FF2B5EF4-FFF2-40B4-BE49-F238E27FC236}">
                  <a16:creationId xmlns:a16="http://schemas.microsoft.com/office/drawing/2014/main" id="{7E2D4155-F40E-449E-FA2E-AF1996D17FA3}"/>
                </a:ext>
              </a:extLst>
            </p:cNvPr>
            <p:cNvSpPr txBox="1"/>
            <p:nvPr/>
          </p:nvSpPr>
          <p:spPr>
            <a:xfrm rot="5400000">
              <a:off x="2056344" y="5247964"/>
              <a:ext cx="542137" cy="3077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400" dirty="0"/>
                <a:t>0cM</a:t>
              </a:r>
              <a:endParaRPr kumimoji="1" lang="ja-JP" altLang="en-US" sz="1400" dirty="0"/>
            </a:p>
          </p:txBody>
        </p:sp>
        <p:sp>
          <p:nvSpPr>
            <p:cNvPr id="21" name="テキスト ボックス 5">
              <a:extLst>
                <a:ext uri="{FF2B5EF4-FFF2-40B4-BE49-F238E27FC236}">
                  <a16:creationId xmlns:a16="http://schemas.microsoft.com/office/drawing/2014/main" id="{1450A129-A378-4098-BC5E-F00B277526EB}"/>
                </a:ext>
              </a:extLst>
            </p:cNvPr>
            <p:cNvSpPr txBox="1"/>
            <p:nvPr/>
          </p:nvSpPr>
          <p:spPr>
            <a:xfrm rot="5400000">
              <a:off x="2948799" y="5297656"/>
              <a:ext cx="641522" cy="3077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400" dirty="0"/>
                <a:t>10cM</a:t>
              </a:r>
              <a:endParaRPr kumimoji="1" lang="ja-JP" altLang="en-US" sz="1400" dirty="0"/>
            </a:p>
          </p:txBody>
        </p:sp>
        <p:sp>
          <p:nvSpPr>
            <p:cNvPr id="22" name="テキスト ボックス 6">
              <a:extLst>
                <a:ext uri="{FF2B5EF4-FFF2-40B4-BE49-F238E27FC236}">
                  <a16:creationId xmlns:a16="http://schemas.microsoft.com/office/drawing/2014/main" id="{9C603F1E-8C69-4A16-B6FA-261E692A5F7A}"/>
                </a:ext>
              </a:extLst>
            </p:cNvPr>
            <p:cNvSpPr txBox="1"/>
            <p:nvPr/>
          </p:nvSpPr>
          <p:spPr>
            <a:xfrm rot="5400000">
              <a:off x="3890946" y="5297656"/>
              <a:ext cx="641522" cy="3077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400" dirty="0"/>
                <a:t>20cM</a:t>
              </a:r>
              <a:endParaRPr kumimoji="1" lang="ja-JP" altLang="en-US" sz="1400" dirty="0"/>
            </a:p>
          </p:txBody>
        </p:sp>
        <p:sp>
          <p:nvSpPr>
            <p:cNvPr id="23" name="テキスト ボックス 7">
              <a:extLst>
                <a:ext uri="{FF2B5EF4-FFF2-40B4-BE49-F238E27FC236}">
                  <a16:creationId xmlns:a16="http://schemas.microsoft.com/office/drawing/2014/main" id="{71A22753-4D37-418F-B67D-82F725400DD9}"/>
                </a:ext>
              </a:extLst>
            </p:cNvPr>
            <p:cNvSpPr txBox="1"/>
            <p:nvPr/>
          </p:nvSpPr>
          <p:spPr>
            <a:xfrm rot="5400000">
              <a:off x="4833093" y="5297656"/>
              <a:ext cx="641522" cy="3077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400" dirty="0"/>
                <a:t>30cM</a:t>
              </a:r>
              <a:endParaRPr kumimoji="1" lang="ja-JP" altLang="en-US" sz="1400" dirty="0"/>
            </a:p>
          </p:txBody>
        </p:sp>
        <p:sp>
          <p:nvSpPr>
            <p:cNvPr id="24" name="テキスト ボックス 8">
              <a:extLst>
                <a:ext uri="{FF2B5EF4-FFF2-40B4-BE49-F238E27FC236}">
                  <a16:creationId xmlns:a16="http://schemas.microsoft.com/office/drawing/2014/main" id="{3D4205DB-232F-4DB7-8B89-F99E7D11AF39}"/>
                </a:ext>
              </a:extLst>
            </p:cNvPr>
            <p:cNvSpPr txBox="1"/>
            <p:nvPr/>
          </p:nvSpPr>
          <p:spPr>
            <a:xfrm rot="5400000">
              <a:off x="5775240" y="5297656"/>
              <a:ext cx="641522" cy="3077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400" dirty="0"/>
                <a:t>40cM</a:t>
              </a:r>
              <a:endParaRPr kumimoji="1" lang="ja-JP" altLang="en-US" sz="1400" dirty="0"/>
            </a:p>
          </p:txBody>
        </p:sp>
        <p:sp>
          <p:nvSpPr>
            <p:cNvPr id="25" name="テキスト ボックス 9">
              <a:extLst>
                <a:ext uri="{FF2B5EF4-FFF2-40B4-BE49-F238E27FC236}">
                  <a16:creationId xmlns:a16="http://schemas.microsoft.com/office/drawing/2014/main" id="{DF0FE578-3EEE-4551-8A27-1C62BDD469DB}"/>
                </a:ext>
              </a:extLst>
            </p:cNvPr>
            <p:cNvSpPr txBox="1"/>
            <p:nvPr/>
          </p:nvSpPr>
          <p:spPr>
            <a:xfrm rot="5400000">
              <a:off x="6717387" y="5297656"/>
              <a:ext cx="641522" cy="3077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400" dirty="0"/>
                <a:t>50cM</a:t>
              </a:r>
              <a:endParaRPr kumimoji="1" lang="ja-JP" altLang="en-US" sz="1400" dirty="0"/>
            </a:p>
          </p:txBody>
        </p:sp>
        <p:sp>
          <p:nvSpPr>
            <p:cNvPr id="26" name="テキスト ボックス 10">
              <a:extLst>
                <a:ext uri="{FF2B5EF4-FFF2-40B4-BE49-F238E27FC236}">
                  <a16:creationId xmlns:a16="http://schemas.microsoft.com/office/drawing/2014/main" id="{630B6528-85BE-42ED-8A89-48D480091BC9}"/>
                </a:ext>
              </a:extLst>
            </p:cNvPr>
            <p:cNvSpPr txBox="1"/>
            <p:nvPr/>
          </p:nvSpPr>
          <p:spPr>
            <a:xfrm rot="5400000">
              <a:off x="7659534" y="5297656"/>
              <a:ext cx="641522" cy="3077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400" dirty="0"/>
                <a:t>60cM</a:t>
              </a:r>
              <a:endParaRPr kumimoji="1" lang="ja-JP" altLang="en-US" sz="1400" dirty="0"/>
            </a:p>
          </p:txBody>
        </p:sp>
        <p:sp>
          <p:nvSpPr>
            <p:cNvPr id="27" name="テキスト ボックス 11">
              <a:extLst>
                <a:ext uri="{FF2B5EF4-FFF2-40B4-BE49-F238E27FC236}">
                  <a16:creationId xmlns:a16="http://schemas.microsoft.com/office/drawing/2014/main" id="{83694123-F931-4321-8895-204D98B5F7F8}"/>
                </a:ext>
              </a:extLst>
            </p:cNvPr>
            <p:cNvSpPr txBox="1"/>
            <p:nvPr/>
          </p:nvSpPr>
          <p:spPr>
            <a:xfrm rot="5400000">
              <a:off x="8601681" y="5297656"/>
              <a:ext cx="641522" cy="3077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400" dirty="0"/>
                <a:t>70cM</a:t>
              </a:r>
              <a:endParaRPr kumimoji="1" lang="ja-JP" altLang="en-US" sz="1400" dirty="0"/>
            </a:p>
          </p:txBody>
        </p:sp>
        <p:sp>
          <p:nvSpPr>
            <p:cNvPr id="28" name="テキスト ボックス 12">
              <a:extLst>
                <a:ext uri="{FF2B5EF4-FFF2-40B4-BE49-F238E27FC236}">
                  <a16:creationId xmlns:a16="http://schemas.microsoft.com/office/drawing/2014/main" id="{6864B472-93EF-4391-89B7-2CC7A4F3F2D6}"/>
                </a:ext>
              </a:extLst>
            </p:cNvPr>
            <p:cNvSpPr txBox="1"/>
            <p:nvPr/>
          </p:nvSpPr>
          <p:spPr>
            <a:xfrm rot="5400000">
              <a:off x="9543826" y="5297656"/>
              <a:ext cx="641522" cy="3077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400" dirty="0"/>
                <a:t>80cM</a:t>
              </a:r>
              <a:endParaRPr kumimoji="1" lang="ja-JP" altLang="en-US" sz="1400" dirty="0"/>
            </a:p>
          </p:txBody>
        </p:sp>
        <p:sp>
          <p:nvSpPr>
            <p:cNvPr id="19" name="テキスト ボックス 16">
              <a:extLst>
                <a:ext uri="{FF2B5EF4-FFF2-40B4-BE49-F238E27FC236}">
                  <a16:creationId xmlns:a16="http://schemas.microsoft.com/office/drawing/2014/main" id="{850B544B-9C72-2086-F784-8237105C36BC}"/>
                </a:ext>
              </a:extLst>
            </p:cNvPr>
            <p:cNvSpPr txBox="1"/>
            <p:nvPr/>
          </p:nvSpPr>
          <p:spPr>
            <a:xfrm rot="5400000">
              <a:off x="9163113" y="5370593"/>
              <a:ext cx="787395" cy="307777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400" dirty="0"/>
                <a:t>77.6cM</a:t>
              </a:r>
              <a:endParaRPr kumimoji="1" lang="ja-JP" altLang="en-US" sz="1400" dirty="0"/>
            </a:p>
          </p:txBody>
        </p:sp>
      </p:grp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282B0ACB-A3FF-3C91-1F58-7BB567897707}"/>
              </a:ext>
            </a:extLst>
          </p:cNvPr>
          <p:cNvCxnSpPr/>
          <p:nvPr/>
        </p:nvCxnSpPr>
        <p:spPr>
          <a:xfrm>
            <a:off x="2411632" y="4181707"/>
            <a:ext cx="7533642" cy="0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8105066-3DE9-A4E5-EEB2-D064CC6D13AB}"/>
              </a:ext>
            </a:extLst>
          </p:cNvPr>
          <p:cNvSpPr txBox="1"/>
          <p:nvPr/>
        </p:nvSpPr>
        <p:spPr>
          <a:xfrm>
            <a:off x="2424796" y="3873930"/>
            <a:ext cx="931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LOD=3.0</a:t>
            </a:r>
            <a:endParaRPr kumimoji="1" lang="ja-JP" altLang="en-US" sz="14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EC1C0A4-DC10-3090-EA2E-F6D03A787FB9}"/>
              </a:ext>
            </a:extLst>
          </p:cNvPr>
          <p:cNvSpPr txBox="1"/>
          <p:nvPr/>
        </p:nvSpPr>
        <p:spPr>
          <a:xfrm>
            <a:off x="2298345" y="6230757"/>
            <a:ext cx="630813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</a:rPr>
              <a:t>The dotted horizontal line indicates the LOD threshold. </a:t>
            </a:r>
          </a:p>
          <a:p>
            <a:r>
              <a:rPr kumimoji="1" lang="en-US" altLang="ja-JP" dirty="0">
                <a:solidFill>
                  <a:srgbClr val="FF0000"/>
                </a:solidFill>
              </a:rPr>
              <a:t>The dotted vertical line </a:t>
            </a:r>
            <a:r>
              <a:rPr lang="en-US" altLang="ja-JP" dirty="0">
                <a:solidFill>
                  <a:srgbClr val="FF0000"/>
                </a:solidFill>
              </a:rPr>
              <a:t>indicates the</a:t>
            </a:r>
            <a:r>
              <a:rPr kumimoji="1" lang="en-US" altLang="ja-JP" dirty="0">
                <a:solidFill>
                  <a:srgbClr val="FF0000"/>
                </a:solidFill>
              </a:rPr>
              <a:t> LOD peak position.</a:t>
            </a:r>
            <a:endParaRPr kumimoji="1" lang="ja-JP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6951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B7F4757F-41CA-8345-CDA1-C9B79B5E1E6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7118177"/>
              </p:ext>
            </p:extLst>
          </p:nvPr>
        </p:nvGraphicFramePr>
        <p:xfrm>
          <a:off x="1234218" y="168834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82DFB45C-A7F1-42E6-AA13-86E8188542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6076305"/>
              </p:ext>
            </p:extLst>
          </p:nvPr>
        </p:nvGraphicFramePr>
        <p:xfrm>
          <a:off x="6203777" y="170360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C6A6B5E-51C3-E1FE-0F63-8869FE3601B9}"/>
              </a:ext>
            </a:extLst>
          </p:cNvPr>
          <p:cNvSpPr txBox="1"/>
          <p:nvPr/>
        </p:nvSpPr>
        <p:spPr>
          <a:xfrm>
            <a:off x="1141600" y="5140473"/>
            <a:ext cx="10715625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S2  Distribution of the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34" charset="-128"/>
                <a:cs typeface="+mn-cs"/>
              </a:rPr>
              <a:t>recombinant inbred lines (</a:t>
            </a:r>
            <a:r>
              <a:rPr kumimoji="1" lang="en-US" altLang="ja-JP" dirty="0"/>
              <a:t>RILs</a:t>
            </a:r>
            <a:r>
              <a:rPr kumimoji="1" lang="en-US" altLang="ja-JP" dirty="0">
                <a:solidFill>
                  <a:srgbClr val="FF0000"/>
                </a:solidFill>
              </a:rPr>
              <a:t>)</a:t>
            </a:r>
            <a:r>
              <a:rPr kumimoji="1" lang="en-US" altLang="ja-JP" dirty="0"/>
              <a:t> for ratio of </a:t>
            </a:r>
            <a:r>
              <a:rPr kumimoji="1" lang="en-US" altLang="ja-JP" dirty="0" err="1"/>
              <a:t>rhizobia</a:t>
            </a:r>
            <a:r>
              <a:rPr kumimoji="1" lang="en-US" altLang="ja-JP" dirty="0" err="1">
                <a:solidFill>
                  <a:srgbClr val="FF0000"/>
                </a:solidFill>
              </a:rPr>
              <a:t>l</a:t>
            </a:r>
            <a:r>
              <a:rPr kumimoji="1" lang="en-US" altLang="ja-JP" dirty="0">
                <a:solidFill>
                  <a:srgbClr val="FF0000"/>
                </a:solidFill>
              </a:rPr>
              <a:t> </a:t>
            </a:r>
            <a:r>
              <a:rPr kumimoji="1" lang="en-US" altLang="ja-JP" dirty="0"/>
              <a:t>strains used homozygous genotypes at the QTL region </a:t>
            </a:r>
            <a:r>
              <a:rPr lang="en-US" altLang="ja-JP" dirty="0">
                <a:solidFill>
                  <a:srgbClr val="FF0000"/>
                </a:solidFill>
              </a:rPr>
              <a:t>among</a:t>
            </a:r>
            <a:r>
              <a:rPr kumimoji="1" lang="en-US" altLang="ja-JP" dirty="0"/>
              <a:t> the </a:t>
            </a:r>
            <a:r>
              <a:rPr kumimoji="1" lang="en-US" altLang="ja-JP" dirty="0">
                <a:solidFill>
                  <a:srgbClr val="FF0000"/>
                </a:solidFill>
              </a:rPr>
              <a:t>RILs</a:t>
            </a:r>
            <a:r>
              <a:rPr lang="en-US" altLang="ja-JP" dirty="0">
                <a:solidFill>
                  <a:srgbClr val="FF0000"/>
                </a:solidFill>
              </a:rPr>
              <a:t> derived</a:t>
            </a:r>
            <a:r>
              <a:rPr kumimoji="1" lang="en-US" altLang="ja-JP" dirty="0">
                <a:solidFill>
                  <a:srgbClr val="FF0000"/>
                </a:solidFill>
              </a:rPr>
              <a:t> </a:t>
            </a:r>
            <a:r>
              <a:rPr kumimoji="1" lang="en-US" altLang="ja-JP" dirty="0"/>
              <a:t>from ‘Peking’ and ‘Tamahomare’ </a:t>
            </a:r>
            <a:endParaRPr kumimoji="1" lang="ja-JP" altLang="en-US" dirty="0"/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39EF1261-BDFB-8848-20AA-144F336F1ED1}"/>
              </a:ext>
            </a:extLst>
          </p:cNvPr>
          <p:cNvGrpSpPr/>
          <p:nvPr/>
        </p:nvGrpSpPr>
        <p:grpSpPr>
          <a:xfrm>
            <a:off x="1600200" y="4480815"/>
            <a:ext cx="3776920" cy="276999"/>
            <a:chOff x="1847850" y="5806639"/>
            <a:chExt cx="3776920" cy="276999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1D10B3E4-D0BF-8BCD-6CB0-DCBD91B403EC}"/>
                </a:ext>
              </a:extLst>
            </p:cNvPr>
            <p:cNvSpPr txBox="1"/>
            <p:nvPr/>
          </p:nvSpPr>
          <p:spPr>
            <a:xfrm>
              <a:off x="4059918" y="5806639"/>
              <a:ext cx="15648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Tamahomare homo</a:t>
              </a:r>
              <a:endParaRPr kumimoji="1" lang="ja-JP" altLang="en-US" sz="1200" dirty="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CA84A9D2-36E5-0E00-0AE0-8B84A390CE48}"/>
                </a:ext>
              </a:extLst>
            </p:cNvPr>
            <p:cNvSpPr txBox="1"/>
            <p:nvPr/>
          </p:nvSpPr>
          <p:spPr>
            <a:xfrm>
              <a:off x="2078718" y="5806639"/>
              <a:ext cx="11079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Peking homo</a:t>
              </a:r>
              <a:endParaRPr kumimoji="1" lang="ja-JP" altLang="en-US" sz="1200" dirty="0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BCA53519-50E4-C1CB-C434-9456A3B0855A}"/>
                </a:ext>
              </a:extLst>
            </p:cNvPr>
            <p:cNvSpPr/>
            <p:nvPr/>
          </p:nvSpPr>
          <p:spPr>
            <a:xfrm>
              <a:off x="1847850" y="5806639"/>
              <a:ext cx="144000" cy="14400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FCD6DCF1-21F2-E3E3-F839-38E67E97158D}"/>
                </a:ext>
              </a:extLst>
            </p:cNvPr>
            <p:cNvSpPr/>
            <p:nvPr/>
          </p:nvSpPr>
          <p:spPr>
            <a:xfrm>
              <a:off x="3726543" y="5854511"/>
              <a:ext cx="144000" cy="144000"/>
            </a:xfrm>
            <a:prstGeom prst="rect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C37CBE1A-400B-A80B-CC3E-26A2545099E2}"/>
              </a:ext>
            </a:extLst>
          </p:cNvPr>
          <p:cNvGrpSpPr/>
          <p:nvPr/>
        </p:nvGrpSpPr>
        <p:grpSpPr>
          <a:xfrm>
            <a:off x="6741974" y="4480814"/>
            <a:ext cx="3776920" cy="276999"/>
            <a:chOff x="1847850" y="5806639"/>
            <a:chExt cx="3776920" cy="276999"/>
          </a:xfrm>
        </p:grpSpPr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050CDDA1-817F-C1F5-D3B9-34FBB2913A2D}"/>
                </a:ext>
              </a:extLst>
            </p:cNvPr>
            <p:cNvSpPr txBox="1"/>
            <p:nvPr/>
          </p:nvSpPr>
          <p:spPr>
            <a:xfrm>
              <a:off x="4059918" y="5806639"/>
              <a:ext cx="15648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Tamahomare homo</a:t>
              </a:r>
              <a:endParaRPr kumimoji="1" lang="ja-JP" altLang="en-US" sz="1200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540BFF4C-6C3F-9441-0BDB-37E21B628F86}"/>
                </a:ext>
              </a:extLst>
            </p:cNvPr>
            <p:cNvSpPr txBox="1"/>
            <p:nvPr/>
          </p:nvSpPr>
          <p:spPr>
            <a:xfrm>
              <a:off x="2078718" y="5806639"/>
              <a:ext cx="11079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Peking homo</a:t>
              </a:r>
              <a:endParaRPr kumimoji="1" lang="ja-JP" altLang="en-US" sz="1200" dirty="0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E50D54CA-E897-17C6-6900-9E1B0EB3C7D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847850" y="5806639"/>
              <a:ext cx="144000" cy="14400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5B1B99D7-47CE-4B0E-1FCD-55E5DDEBBEFB}"/>
                </a:ext>
              </a:extLst>
            </p:cNvPr>
            <p:cNvSpPr/>
            <p:nvPr/>
          </p:nvSpPr>
          <p:spPr>
            <a:xfrm>
              <a:off x="3726543" y="5854511"/>
              <a:ext cx="144000" cy="144000"/>
            </a:xfrm>
            <a:prstGeom prst="rect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A42A23B-8E79-1855-B2DF-5B7CD78CB14D}"/>
              </a:ext>
            </a:extLst>
          </p:cNvPr>
          <p:cNvSpPr txBox="1"/>
          <p:nvPr/>
        </p:nvSpPr>
        <p:spPr>
          <a:xfrm>
            <a:off x="10544937" y="4183483"/>
            <a:ext cx="5485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(%)</a:t>
            </a:r>
            <a:endParaRPr kumimoji="1" lang="ja-JP" altLang="en-US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22F11C4-2444-ECC6-1393-9E06A82CB310}"/>
              </a:ext>
            </a:extLst>
          </p:cNvPr>
          <p:cNvSpPr txBox="1"/>
          <p:nvPr/>
        </p:nvSpPr>
        <p:spPr>
          <a:xfrm>
            <a:off x="5629186" y="4133573"/>
            <a:ext cx="5485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(%)</a:t>
            </a:r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7892B9B-22F5-D455-E2AF-997A3A4C46A1}"/>
              </a:ext>
            </a:extLst>
          </p:cNvPr>
          <p:cNvSpPr txBox="1"/>
          <p:nvPr/>
        </p:nvSpPr>
        <p:spPr>
          <a:xfrm rot="5400000">
            <a:off x="5409060" y="3030923"/>
            <a:ext cx="1390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No. of lines</a:t>
            </a:r>
            <a:endParaRPr kumimoji="1" lang="ja-JP" altLang="en-US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B38EEB5-1EEF-30DB-F1A8-D6FAE582C506}"/>
              </a:ext>
            </a:extLst>
          </p:cNvPr>
          <p:cNvSpPr txBox="1"/>
          <p:nvPr/>
        </p:nvSpPr>
        <p:spPr>
          <a:xfrm rot="5400000">
            <a:off x="449373" y="3075366"/>
            <a:ext cx="1390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No. of lines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7869916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四角形: 角を丸くする 1">
            <a:extLst>
              <a:ext uri="{FF2B5EF4-FFF2-40B4-BE49-F238E27FC236}">
                <a16:creationId xmlns:a16="http://schemas.microsoft.com/office/drawing/2014/main" id="{0FDD88B0-C5B7-8149-F9FD-8DE70ADFC0D5}"/>
              </a:ext>
            </a:extLst>
          </p:cNvPr>
          <p:cNvSpPr/>
          <p:nvPr/>
        </p:nvSpPr>
        <p:spPr>
          <a:xfrm>
            <a:off x="3167270" y="1477617"/>
            <a:ext cx="5499652" cy="424070"/>
          </a:xfrm>
          <a:prstGeom prst="roundRect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CA40C7B-4E9D-BE83-F984-D354EFBF5F40}"/>
              </a:ext>
            </a:extLst>
          </p:cNvPr>
          <p:cNvSpPr txBox="1"/>
          <p:nvPr/>
        </p:nvSpPr>
        <p:spPr>
          <a:xfrm>
            <a:off x="2020957" y="1532355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hr.18</a:t>
            </a:r>
            <a:endParaRPr kumimoji="1" lang="ja-JP" altLang="en-US" dirty="0"/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DDF2DD7B-A850-3606-8223-01DD50E9CB2D}"/>
              </a:ext>
            </a:extLst>
          </p:cNvPr>
          <p:cNvCxnSpPr/>
          <p:nvPr/>
        </p:nvCxnSpPr>
        <p:spPr>
          <a:xfrm>
            <a:off x="7759148" y="1901687"/>
            <a:ext cx="0" cy="17890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1B006F88-DF2E-8A2B-D769-D4BC3EF7263F}"/>
              </a:ext>
            </a:extLst>
          </p:cNvPr>
          <p:cNvCxnSpPr/>
          <p:nvPr/>
        </p:nvCxnSpPr>
        <p:spPr>
          <a:xfrm>
            <a:off x="8070574" y="1901687"/>
            <a:ext cx="0" cy="17890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D45EBB9D-656C-6A49-6D7F-5D66444BD2FE}"/>
              </a:ext>
            </a:extLst>
          </p:cNvPr>
          <p:cNvCxnSpPr>
            <a:cxnSpLocks/>
          </p:cNvCxnSpPr>
          <p:nvPr/>
        </p:nvCxnSpPr>
        <p:spPr>
          <a:xfrm flipH="1">
            <a:off x="3220278" y="2080591"/>
            <a:ext cx="4538870" cy="11065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3E0BCA12-5CDE-2EBB-EAA0-685FD8FB3A97}"/>
              </a:ext>
            </a:extLst>
          </p:cNvPr>
          <p:cNvCxnSpPr>
            <a:cxnSpLocks/>
          </p:cNvCxnSpPr>
          <p:nvPr/>
        </p:nvCxnSpPr>
        <p:spPr>
          <a:xfrm>
            <a:off x="8070574" y="2080591"/>
            <a:ext cx="755374" cy="110655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2C5E7A56-E7E3-C303-730F-AF18D895F742}"/>
              </a:ext>
            </a:extLst>
          </p:cNvPr>
          <p:cNvCxnSpPr/>
          <p:nvPr/>
        </p:nvCxnSpPr>
        <p:spPr>
          <a:xfrm>
            <a:off x="3306417" y="3366052"/>
            <a:ext cx="0" cy="3644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A49AFD9C-BBAF-04EF-B0AB-45D7E6CD3584}"/>
              </a:ext>
            </a:extLst>
          </p:cNvPr>
          <p:cNvCxnSpPr/>
          <p:nvPr/>
        </p:nvCxnSpPr>
        <p:spPr>
          <a:xfrm>
            <a:off x="3306417" y="3571461"/>
            <a:ext cx="551953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2101B3CB-6A5A-AE46-0DCC-2D459C820F13}"/>
              </a:ext>
            </a:extLst>
          </p:cNvPr>
          <p:cNvCxnSpPr/>
          <p:nvPr/>
        </p:nvCxnSpPr>
        <p:spPr>
          <a:xfrm>
            <a:off x="8819329" y="3385932"/>
            <a:ext cx="0" cy="3644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317909DB-513C-3F00-1C86-D6E3C72E7800}"/>
              </a:ext>
            </a:extLst>
          </p:cNvPr>
          <p:cNvCxnSpPr/>
          <p:nvPr/>
        </p:nvCxnSpPr>
        <p:spPr>
          <a:xfrm>
            <a:off x="4790668" y="3385932"/>
            <a:ext cx="0" cy="3644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84CAAE16-D9AF-46A0-DFE1-03D893D67A99}"/>
              </a:ext>
            </a:extLst>
          </p:cNvPr>
          <p:cNvCxnSpPr/>
          <p:nvPr/>
        </p:nvCxnSpPr>
        <p:spPr>
          <a:xfrm>
            <a:off x="6294790" y="3389243"/>
            <a:ext cx="0" cy="3644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40F72DC9-AACD-454C-AAB7-960A1F32A427}"/>
              </a:ext>
            </a:extLst>
          </p:cNvPr>
          <p:cNvCxnSpPr/>
          <p:nvPr/>
        </p:nvCxnSpPr>
        <p:spPr>
          <a:xfrm>
            <a:off x="7169434" y="3389243"/>
            <a:ext cx="0" cy="3644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6BABA37-961E-D671-0D26-7B43AE704C9E}"/>
              </a:ext>
            </a:extLst>
          </p:cNvPr>
          <p:cNvSpPr txBox="1"/>
          <p:nvPr/>
        </p:nvSpPr>
        <p:spPr>
          <a:xfrm>
            <a:off x="2908852" y="3114597"/>
            <a:ext cx="7986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</a:rPr>
              <a:t>A08389</a:t>
            </a:r>
            <a:endParaRPr kumimoji="1" lang="ja-JP" altLang="en-US" sz="1400" dirty="0">
              <a:solidFill>
                <a:srgbClr val="FF0000"/>
              </a:solidFill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0E24967-6EE3-247A-37CA-B6B952195EAC}"/>
              </a:ext>
            </a:extLst>
          </p:cNvPr>
          <p:cNvSpPr txBox="1"/>
          <p:nvPr/>
        </p:nvSpPr>
        <p:spPr>
          <a:xfrm>
            <a:off x="8338756" y="3132652"/>
            <a:ext cx="7986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</a:rPr>
              <a:t>A35793</a:t>
            </a:r>
            <a:endParaRPr kumimoji="1" lang="ja-JP" altLang="en-US" sz="1400" dirty="0">
              <a:solidFill>
                <a:srgbClr val="FF0000"/>
              </a:solidFill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C029A68-B328-3F42-F73A-ABFD8F72AE59}"/>
              </a:ext>
            </a:extLst>
          </p:cNvPr>
          <p:cNvSpPr txBox="1"/>
          <p:nvPr/>
        </p:nvSpPr>
        <p:spPr>
          <a:xfrm>
            <a:off x="8345391" y="3795262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57,317kb</a:t>
            </a:r>
            <a:endParaRPr kumimoji="1" lang="ja-JP" altLang="en-US" sz="14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FCB4955-7B06-90D6-9CD7-0D627942942E}"/>
              </a:ext>
            </a:extLst>
          </p:cNvPr>
          <p:cNvSpPr txBox="1"/>
          <p:nvPr/>
        </p:nvSpPr>
        <p:spPr>
          <a:xfrm>
            <a:off x="6781635" y="3782007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56,531kb</a:t>
            </a:r>
            <a:endParaRPr kumimoji="1" lang="ja-JP" altLang="en-US" sz="14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00F998E-30FA-5D3A-AA60-87D8C000B7E7}"/>
              </a:ext>
            </a:extLst>
          </p:cNvPr>
          <p:cNvSpPr txBox="1"/>
          <p:nvPr/>
        </p:nvSpPr>
        <p:spPr>
          <a:xfrm>
            <a:off x="5858090" y="3793773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56,334kb</a:t>
            </a:r>
            <a:endParaRPr kumimoji="1" lang="ja-JP" altLang="en-US" sz="14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8766065-9512-3135-222E-60DE050226E7}"/>
              </a:ext>
            </a:extLst>
          </p:cNvPr>
          <p:cNvSpPr txBox="1"/>
          <p:nvPr/>
        </p:nvSpPr>
        <p:spPr>
          <a:xfrm>
            <a:off x="5831361" y="3131165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Sat_064</a:t>
            </a:r>
            <a:endParaRPr kumimoji="1" lang="ja-JP" altLang="en-US" sz="1400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1C23903-194E-5971-42C9-01C6D280B52D}"/>
              </a:ext>
            </a:extLst>
          </p:cNvPr>
          <p:cNvSpPr txBox="1"/>
          <p:nvPr/>
        </p:nvSpPr>
        <p:spPr>
          <a:xfrm>
            <a:off x="6758451" y="3119907"/>
            <a:ext cx="7986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</a:rPr>
              <a:t>A01978</a:t>
            </a:r>
            <a:endParaRPr kumimoji="1" lang="ja-JP" altLang="en-US" sz="1400" dirty="0">
              <a:solidFill>
                <a:srgbClr val="FF0000"/>
              </a:solidFill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B9CF276-5FEF-79EC-1105-55268CD38E13}"/>
              </a:ext>
            </a:extLst>
          </p:cNvPr>
          <p:cNvSpPr txBox="1"/>
          <p:nvPr/>
        </p:nvSpPr>
        <p:spPr>
          <a:xfrm>
            <a:off x="700131" y="4903546"/>
            <a:ext cx="106363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S3  Schematic view of </a:t>
            </a:r>
            <a:r>
              <a:rPr lang="en-US" altLang="ja-JP" dirty="0"/>
              <a:t>the </a:t>
            </a:r>
            <a:r>
              <a:rPr lang="en-US" altLang="ja-JP" dirty="0">
                <a:solidFill>
                  <a:srgbClr val="FF0000"/>
                </a:solidFill>
              </a:rPr>
              <a:t>location</a:t>
            </a:r>
            <a:r>
              <a:rPr kumimoji="1" lang="en-US" altLang="ja-JP" dirty="0"/>
              <a:t> of molecular markers </a:t>
            </a:r>
            <a:r>
              <a:rPr lang="en-US" altLang="ja-JP" dirty="0">
                <a:solidFill>
                  <a:srgbClr val="FF0000"/>
                </a:solidFill>
              </a:rPr>
              <a:t>in the sequences surrounding</a:t>
            </a:r>
            <a:r>
              <a:rPr kumimoji="1" lang="en-US" altLang="ja-JP" dirty="0">
                <a:solidFill>
                  <a:srgbClr val="FF0000"/>
                </a:solidFill>
              </a:rPr>
              <a:t> </a:t>
            </a:r>
            <a:r>
              <a:rPr kumimoji="1" lang="en-US" altLang="ja-JP" dirty="0"/>
              <a:t>the QTL region on Chromosome 18  </a:t>
            </a:r>
            <a:endParaRPr kumimoji="1"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839977A-CB89-159E-8F00-2AEC71F78AED}"/>
              </a:ext>
            </a:extLst>
          </p:cNvPr>
          <p:cNvSpPr txBox="1"/>
          <p:nvPr/>
        </p:nvSpPr>
        <p:spPr>
          <a:xfrm>
            <a:off x="2896518" y="3782006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52,593kb</a:t>
            </a:r>
            <a:endParaRPr kumimoji="1" lang="ja-JP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FC7CCC7-71FF-B5A5-50C8-AA0CB8FD0383}"/>
              </a:ext>
            </a:extLst>
          </p:cNvPr>
          <p:cNvSpPr txBox="1"/>
          <p:nvPr/>
        </p:nvSpPr>
        <p:spPr>
          <a:xfrm>
            <a:off x="4412973" y="3110661"/>
            <a:ext cx="7986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</a:rPr>
              <a:t>A16649</a:t>
            </a:r>
            <a:endParaRPr kumimoji="1" lang="ja-JP" altLang="en-US" sz="1400" dirty="0">
              <a:solidFill>
                <a:srgbClr val="FF0000"/>
              </a:solidFill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A69155A-8F8E-AB7B-F927-C2F4CBB1343A}"/>
              </a:ext>
            </a:extLst>
          </p:cNvPr>
          <p:cNvSpPr txBox="1"/>
          <p:nvPr/>
        </p:nvSpPr>
        <p:spPr>
          <a:xfrm>
            <a:off x="4282951" y="3778556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55,357kb</a:t>
            </a:r>
            <a:endParaRPr kumimoji="1" lang="ja-JP" altLang="en-US" sz="14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5B60F70-CFA6-3428-D35F-2239CF99E75A}"/>
              </a:ext>
            </a:extLst>
          </p:cNvPr>
          <p:cNvSpPr txBox="1"/>
          <p:nvPr/>
        </p:nvSpPr>
        <p:spPr>
          <a:xfrm>
            <a:off x="2843790" y="4063329"/>
            <a:ext cx="925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(72.0cM)</a:t>
            </a:r>
            <a:endParaRPr kumimoji="1" lang="ja-JP" altLang="en-US" sz="14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CEA7990-70B7-36EF-E2B7-30790193EF9F}"/>
              </a:ext>
            </a:extLst>
          </p:cNvPr>
          <p:cNvSpPr txBox="1"/>
          <p:nvPr/>
        </p:nvSpPr>
        <p:spPr>
          <a:xfrm>
            <a:off x="4282951" y="4063329"/>
            <a:ext cx="925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(74.7cM)</a:t>
            </a:r>
            <a:endParaRPr kumimoji="1" lang="ja-JP" altLang="en-US" sz="14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12BF569-6C1B-9E4F-5A86-DD664E2171CA}"/>
              </a:ext>
            </a:extLst>
          </p:cNvPr>
          <p:cNvSpPr txBox="1"/>
          <p:nvPr/>
        </p:nvSpPr>
        <p:spPr>
          <a:xfrm>
            <a:off x="6758451" y="4063329"/>
            <a:ext cx="925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(76.6cM)</a:t>
            </a:r>
            <a:endParaRPr kumimoji="1" lang="ja-JP" altLang="en-US" sz="14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C256B66-0D98-4292-70DC-4630D2F5C1D6}"/>
              </a:ext>
            </a:extLst>
          </p:cNvPr>
          <p:cNvSpPr txBox="1"/>
          <p:nvPr/>
        </p:nvSpPr>
        <p:spPr>
          <a:xfrm>
            <a:off x="8308698" y="4063329"/>
            <a:ext cx="925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(80.6cM)</a:t>
            </a:r>
            <a:endParaRPr kumimoji="1" lang="ja-JP" altLang="en-US" sz="14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5475C5E-D1E4-5185-A498-F1F4AB790FE3}"/>
              </a:ext>
            </a:extLst>
          </p:cNvPr>
          <p:cNvSpPr txBox="1"/>
          <p:nvPr/>
        </p:nvSpPr>
        <p:spPr>
          <a:xfrm>
            <a:off x="805767" y="5643486"/>
            <a:ext cx="105208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08389, A16649, A01978</a:t>
            </a:r>
            <a:r>
              <a:rPr lang="en-US" altLang="ja-JP" dirty="0">
                <a:solidFill>
                  <a:srgbClr val="FF0000"/>
                </a:solidFill>
              </a:rPr>
              <a:t>,</a:t>
            </a:r>
            <a:r>
              <a:rPr lang="en-US" altLang="ja-JP" dirty="0"/>
              <a:t> and A35793 are G</a:t>
            </a:r>
            <a:r>
              <a:rPr lang="en-US" altLang="ja-JP" dirty="0">
                <a:solidFill>
                  <a:srgbClr val="FF0000"/>
                </a:solidFill>
              </a:rPr>
              <a:t>RAS-D</a:t>
            </a:r>
            <a:r>
              <a:rPr lang="en-US" altLang="ja-JP" dirty="0"/>
              <a:t>i markers.</a:t>
            </a:r>
          </a:p>
          <a:p>
            <a:r>
              <a:rPr lang="en-US" altLang="ja-JP" dirty="0"/>
              <a:t>‘Sat_064’ is </a:t>
            </a:r>
            <a:r>
              <a:rPr lang="en-US" altLang="ja-JP" dirty="0">
                <a:solidFill>
                  <a:srgbClr val="FF0000"/>
                </a:solidFill>
              </a:rPr>
              <a:t>an </a:t>
            </a:r>
            <a:r>
              <a:rPr lang="en-US" altLang="ja-JP" dirty="0"/>
              <a:t>SSR marker </a:t>
            </a:r>
            <a:r>
              <a:rPr lang="en-US" altLang="ja-JP" dirty="0">
                <a:solidFill>
                  <a:srgbClr val="FF0000"/>
                </a:solidFill>
              </a:rPr>
              <a:t>in the proximity of the QTL detected by</a:t>
            </a:r>
            <a:r>
              <a:rPr lang="en-US" altLang="ja-JP" dirty="0"/>
              <a:t> </a:t>
            </a:r>
            <a:r>
              <a:rPr lang="en-US" altLang="ja-JP" dirty="0" err="1"/>
              <a:t>Ramongolalaina</a:t>
            </a:r>
            <a:r>
              <a:rPr lang="en-US" altLang="ja-JP" dirty="0"/>
              <a:t> </a:t>
            </a:r>
            <a:r>
              <a:rPr lang="en-US" altLang="ja-JP" i="1" dirty="0">
                <a:solidFill>
                  <a:srgbClr val="FF0000"/>
                </a:solidFill>
              </a:rPr>
              <a:t>et al</a:t>
            </a:r>
            <a:r>
              <a:rPr lang="en-US" altLang="ja-JP" dirty="0">
                <a:solidFill>
                  <a:srgbClr val="FF0000"/>
                </a:solidFill>
              </a:rPr>
              <a:t>. </a:t>
            </a:r>
            <a:r>
              <a:rPr lang="en-US" altLang="ja-JP" dirty="0"/>
              <a:t>(2018) 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184627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799DD0B-BF7C-0194-6419-ED5FA90E8B9E}"/>
              </a:ext>
            </a:extLst>
          </p:cNvPr>
          <p:cNvSpPr txBox="1"/>
          <p:nvPr/>
        </p:nvSpPr>
        <p:spPr>
          <a:xfrm>
            <a:off x="867746" y="5657671"/>
            <a:ext cx="999329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</a:t>
            </a:r>
            <a:r>
              <a:rPr lang="en-US" altLang="ja-JP" dirty="0"/>
              <a:t>S4  </a:t>
            </a:r>
            <a:r>
              <a:rPr kumimoji="1" lang="en-US" altLang="ja-JP" dirty="0"/>
              <a:t>Heatmap of the 22 candidate genes in ‘Peking’ and ‘Tamahomare’.</a:t>
            </a:r>
          </a:p>
          <a:p>
            <a:r>
              <a:rPr lang="en-US" altLang="ja-JP" dirty="0">
                <a:solidFill>
                  <a:srgbClr val="FF0000"/>
                </a:solidFill>
              </a:rPr>
              <a:t>The green and red blocks represent overexpressed and </a:t>
            </a:r>
            <a:r>
              <a:rPr lang="en-US" altLang="ja-JP" dirty="0" err="1">
                <a:solidFill>
                  <a:srgbClr val="FF0000"/>
                </a:solidFill>
              </a:rPr>
              <a:t>underexpressed</a:t>
            </a:r>
            <a:r>
              <a:rPr lang="en-US" altLang="ja-JP" dirty="0">
                <a:solidFill>
                  <a:srgbClr val="FF0000"/>
                </a:solidFill>
              </a:rPr>
              <a:t> genes, respectively.</a:t>
            </a:r>
          </a:p>
          <a:p>
            <a:r>
              <a:rPr kumimoji="1" lang="en-US" altLang="ja-JP" dirty="0"/>
              <a:t>P1</a:t>
            </a:r>
            <a:r>
              <a:rPr kumimoji="1" lang="en-US" altLang="ja-JP" dirty="0">
                <a:solidFill>
                  <a:srgbClr val="FF0000"/>
                </a:solidFill>
              </a:rPr>
              <a:t>–</a:t>
            </a:r>
            <a:r>
              <a:rPr kumimoji="1" lang="en-US" altLang="ja-JP" dirty="0"/>
              <a:t>P3 indicate </a:t>
            </a:r>
            <a:r>
              <a:rPr kumimoji="1" lang="en-US" altLang="ja-JP" dirty="0">
                <a:solidFill>
                  <a:srgbClr val="FF0000"/>
                </a:solidFill>
              </a:rPr>
              <a:t>the</a:t>
            </a:r>
            <a:r>
              <a:rPr kumimoji="1" lang="en-US" altLang="ja-JP" dirty="0"/>
              <a:t> replicates of ‘Peking’, and T1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34" charset="-128"/>
                <a:cs typeface="+mn-cs"/>
              </a:rPr>
              <a:t>–</a:t>
            </a:r>
            <a:r>
              <a:rPr lang="en-US" altLang="ja-JP" dirty="0"/>
              <a:t>T3 indicated those of ‘Tamahomare’</a:t>
            </a:r>
            <a:endParaRPr kumimoji="1" lang="ja-JP" altLang="en-US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18878495-F762-8EEF-B222-DA3B82C427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85" y="1562440"/>
            <a:ext cx="12192000" cy="4163568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54878374-4F81-9407-70DC-295F7CEAA0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60766" y="1571625"/>
            <a:ext cx="906449" cy="3764361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4E5ABF72-4D4C-1FCE-7B39-2C61715DF3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785" y="0"/>
            <a:ext cx="1685925" cy="1571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48284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FBB84439-0141-303F-ED06-237F2D124498}"/>
              </a:ext>
            </a:extLst>
          </p:cNvPr>
          <p:cNvSpPr/>
          <p:nvPr/>
        </p:nvSpPr>
        <p:spPr>
          <a:xfrm>
            <a:off x="1102647" y="1540494"/>
            <a:ext cx="7784757" cy="72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bg1"/>
              </a:solidFill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C13DDBA1-F07A-B5C7-977E-8CDB0031B47A}"/>
              </a:ext>
            </a:extLst>
          </p:cNvPr>
          <p:cNvGrpSpPr/>
          <p:nvPr/>
        </p:nvGrpSpPr>
        <p:grpSpPr>
          <a:xfrm>
            <a:off x="1093461" y="1532632"/>
            <a:ext cx="7784756" cy="720000"/>
            <a:chOff x="2203621" y="2605555"/>
            <a:chExt cx="7784756" cy="720000"/>
          </a:xfrm>
        </p:grpSpPr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34E96AC5-18F3-5DE2-87C5-6ADDCEA44B71}"/>
                </a:ext>
              </a:extLst>
            </p:cNvPr>
            <p:cNvSpPr/>
            <p:nvPr/>
          </p:nvSpPr>
          <p:spPr>
            <a:xfrm>
              <a:off x="2203621" y="2605555"/>
              <a:ext cx="1201401" cy="720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F8233B37-B899-A60A-5DA9-860056924D2B}"/>
                </a:ext>
              </a:extLst>
            </p:cNvPr>
            <p:cNvSpPr/>
            <p:nvPr/>
          </p:nvSpPr>
          <p:spPr>
            <a:xfrm>
              <a:off x="8786976" y="2605555"/>
              <a:ext cx="1201401" cy="720000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E366C7DE-2825-1B60-EBC5-ED4005CDBABA}"/>
                </a:ext>
              </a:extLst>
            </p:cNvPr>
            <p:cNvSpPr/>
            <p:nvPr/>
          </p:nvSpPr>
          <p:spPr>
            <a:xfrm>
              <a:off x="5005835" y="2605555"/>
              <a:ext cx="720000" cy="7200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DE6CF745-54C6-577D-EA20-3D4537B81A2C}"/>
                </a:ext>
              </a:extLst>
            </p:cNvPr>
            <p:cNvSpPr/>
            <p:nvPr/>
          </p:nvSpPr>
          <p:spPr>
            <a:xfrm>
              <a:off x="5911933" y="2605555"/>
              <a:ext cx="720000" cy="720000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8C761D90-FDE2-16B4-DF0E-E922016D35C8}"/>
              </a:ext>
            </a:extLst>
          </p:cNvPr>
          <p:cNvGrpSpPr/>
          <p:nvPr/>
        </p:nvGrpSpPr>
        <p:grpSpPr>
          <a:xfrm>
            <a:off x="1093460" y="1220300"/>
            <a:ext cx="7793944" cy="369332"/>
            <a:chOff x="2203620" y="3143668"/>
            <a:chExt cx="7793944" cy="369332"/>
          </a:xfrm>
        </p:grpSpPr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5FA9DEF6-3773-C9C9-494B-C515599FEFB0}"/>
                </a:ext>
              </a:extLst>
            </p:cNvPr>
            <p:cNvSpPr txBox="1"/>
            <p:nvPr/>
          </p:nvSpPr>
          <p:spPr>
            <a:xfrm>
              <a:off x="2203620" y="3143668"/>
              <a:ext cx="12105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6S rRNA</a:t>
              </a:r>
              <a:endParaRPr kumimoji="1" lang="ja-JP" altLang="en-US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4134BFFC-5382-3AE0-6915-8FF98F293FA4}"/>
                </a:ext>
              </a:extLst>
            </p:cNvPr>
            <p:cNvSpPr txBox="1"/>
            <p:nvPr/>
          </p:nvSpPr>
          <p:spPr>
            <a:xfrm>
              <a:off x="8786976" y="3143668"/>
              <a:ext cx="12105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23</a:t>
              </a:r>
              <a:r>
                <a:rPr kumimoji="1" lang="en-US" altLang="ja-JP" dirty="0"/>
                <a:t>S rRNA</a:t>
              </a:r>
              <a:endParaRPr kumimoji="1" lang="ja-JP" altLang="en-US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92DEA0AA-A35A-64FC-30AA-36EA96687206}"/>
                </a:ext>
              </a:extLst>
            </p:cNvPr>
            <p:cNvSpPr txBox="1"/>
            <p:nvPr/>
          </p:nvSpPr>
          <p:spPr>
            <a:xfrm>
              <a:off x="4658834" y="3143668"/>
              <a:ext cx="10999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RNA-Ile</a:t>
              </a:r>
              <a:endParaRPr kumimoji="1" lang="ja-JP" altLang="en-US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AC66757D-EC3C-8E71-090A-DB4899BBE0E5}"/>
                </a:ext>
              </a:extLst>
            </p:cNvPr>
            <p:cNvSpPr txBox="1"/>
            <p:nvPr/>
          </p:nvSpPr>
          <p:spPr>
            <a:xfrm>
              <a:off x="5788743" y="3143668"/>
              <a:ext cx="11817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RNA-Ala</a:t>
              </a:r>
              <a:endParaRPr kumimoji="1" lang="ja-JP" altLang="en-US" dirty="0"/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E2830944-295A-3E23-E5CE-C37D333F4D31}"/>
              </a:ext>
            </a:extLst>
          </p:cNvPr>
          <p:cNvGrpSpPr/>
          <p:nvPr/>
        </p:nvGrpSpPr>
        <p:grpSpPr>
          <a:xfrm>
            <a:off x="1873201" y="2415026"/>
            <a:ext cx="6306246" cy="0"/>
            <a:chOff x="2936759" y="4338394"/>
            <a:chExt cx="6306246" cy="0"/>
          </a:xfrm>
        </p:grpSpPr>
        <p:cxnSp>
          <p:nvCxnSpPr>
            <p:cNvPr id="19" name="直線矢印コネクタ 18">
              <a:extLst>
                <a:ext uri="{FF2B5EF4-FFF2-40B4-BE49-F238E27FC236}">
                  <a16:creationId xmlns:a16="http://schemas.microsoft.com/office/drawing/2014/main" id="{E4776608-DF9C-A782-5CD8-BE8518795003}"/>
                </a:ext>
              </a:extLst>
            </p:cNvPr>
            <p:cNvCxnSpPr>
              <a:cxnSpLocks/>
            </p:cNvCxnSpPr>
            <p:nvPr/>
          </p:nvCxnSpPr>
          <p:spPr>
            <a:xfrm>
              <a:off x="2936759" y="4338394"/>
              <a:ext cx="40714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矢印コネクタ 19">
              <a:extLst>
                <a:ext uri="{FF2B5EF4-FFF2-40B4-BE49-F238E27FC236}">
                  <a16:creationId xmlns:a16="http://schemas.microsoft.com/office/drawing/2014/main" id="{621D250B-9547-3249-DF1B-4CC1F9B6736D}"/>
                </a:ext>
              </a:extLst>
            </p:cNvPr>
            <p:cNvCxnSpPr>
              <a:cxnSpLocks/>
            </p:cNvCxnSpPr>
            <p:nvPr/>
          </p:nvCxnSpPr>
          <p:spPr>
            <a:xfrm>
              <a:off x="8835863" y="4338394"/>
              <a:ext cx="407142" cy="0"/>
            </a:xfrm>
            <a:prstGeom prst="straightConnector1">
              <a:avLst/>
            </a:prstGeom>
            <a:ln>
              <a:headEnd type="triangle"/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5276B87-D980-F8F8-0FA0-2D071925487E}"/>
              </a:ext>
            </a:extLst>
          </p:cNvPr>
          <p:cNvSpPr txBox="1"/>
          <p:nvPr/>
        </p:nvSpPr>
        <p:spPr>
          <a:xfrm>
            <a:off x="1694161" y="2415026"/>
            <a:ext cx="7841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ITS-F</a:t>
            </a:r>
            <a:endParaRPr kumimoji="1" lang="ja-JP" altLang="en-US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1D2EDD4-E2CC-C1DF-C2B6-EB93C8C73FCE}"/>
              </a:ext>
            </a:extLst>
          </p:cNvPr>
          <p:cNvSpPr txBox="1"/>
          <p:nvPr/>
        </p:nvSpPr>
        <p:spPr>
          <a:xfrm>
            <a:off x="7537179" y="2415026"/>
            <a:ext cx="797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ITS-R</a:t>
            </a:r>
            <a:endParaRPr kumimoji="1" lang="ja-JP" altLang="en-US" dirty="0"/>
          </a:p>
        </p:txBody>
      </p: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6F9582DB-4434-B598-C1D0-843F25AB5E83}"/>
              </a:ext>
            </a:extLst>
          </p:cNvPr>
          <p:cNvGrpSpPr/>
          <p:nvPr/>
        </p:nvGrpSpPr>
        <p:grpSpPr>
          <a:xfrm flipH="1">
            <a:off x="7676816" y="2870412"/>
            <a:ext cx="1789159" cy="209457"/>
            <a:chOff x="4800600" y="4578674"/>
            <a:chExt cx="1789159" cy="209457"/>
          </a:xfrm>
        </p:grpSpPr>
        <p:cxnSp>
          <p:nvCxnSpPr>
            <p:cNvPr id="25" name="直線矢印コネクタ 24">
              <a:extLst>
                <a:ext uri="{FF2B5EF4-FFF2-40B4-BE49-F238E27FC236}">
                  <a16:creationId xmlns:a16="http://schemas.microsoft.com/office/drawing/2014/main" id="{7C928CF4-0026-566F-7E7B-5CE1B7AA0708}"/>
                </a:ext>
              </a:extLst>
            </p:cNvPr>
            <p:cNvCxnSpPr/>
            <p:nvPr/>
          </p:nvCxnSpPr>
          <p:spPr>
            <a:xfrm>
              <a:off x="5902747" y="4578674"/>
              <a:ext cx="68701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5DE72543-FCD3-B2CC-4934-79C2185E231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00600" y="4667596"/>
              <a:ext cx="619055" cy="1205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0C7D811B-7C57-E745-AC45-2793DD9F12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19655" y="4578674"/>
              <a:ext cx="483092" cy="88922"/>
            </a:xfrm>
            <a:prstGeom prst="line">
              <a:avLst/>
            </a:prstGeom>
            <a:ln w="15875">
              <a:solidFill>
                <a:schemeClr val="tx1"/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937231B1-4018-B084-E021-69F57CE54779}"/>
              </a:ext>
            </a:extLst>
          </p:cNvPr>
          <p:cNvGrpSpPr/>
          <p:nvPr/>
        </p:nvGrpSpPr>
        <p:grpSpPr>
          <a:xfrm>
            <a:off x="3672429" y="2870412"/>
            <a:ext cx="1789159" cy="209457"/>
            <a:chOff x="4800600" y="4578674"/>
            <a:chExt cx="1789159" cy="209457"/>
          </a:xfrm>
        </p:grpSpPr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id="{F01D7D83-8FEF-6AF8-4AE3-4E3C413355B3}"/>
                </a:ext>
              </a:extLst>
            </p:cNvPr>
            <p:cNvCxnSpPr/>
            <p:nvPr/>
          </p:nvCxnSpPr>
          <p:spPr>
            <a:xfrm>
              <a:off x="5902747" y="4578674"/>
              <a:ext cx="68701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66FA519C-BE71-0732-1CB4-F0EB69658FD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00600" y="4667596"/>
              <a:ext cx="619055" cy="1205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750BE199-1BBA-C45D-4807-4DFB11F4B6E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19655" y="4578674"/>
              <a:ext cx="483092" cy="88922"/>
            </a:xfrm>
            <a:prstGeom prst="line">
              <a:avLst/>
            </a:prstGeom>
            <a:ln w="15875">
              <a:solidFill>
                <a:schemeClr val="tx1"/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1F76E70-4D7C-66C3-81A4-4E7F2E1B4DDA}"/>
              </a:ext>
            </a:extLst>
          </p:cNvPr>
          <p:cNvSpPr txBox="1"/>
          <p:nvPr/>
        </p:nvSpPr>
        <p:spPr>
          <a:xfrm>
            <a:off x="911842" y="4798377"/>
            <a:ext cx="10829809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dirty="0"/>
              <a:t>Figure S5  Schematic representation of PCR amplification for </a:t>
            </a:r>
            <a:r>
              <a:rPr kumimoji="1" lang="en-US" altLang="ja-JP" dirty="0">
                <a:solidFill>
                  <a:srgbClr val="FF0000"/>
                </a:solidFill>
              </a:rPr>
              <a:t>the</a:t>
            </a:r>
            <a:r>
              <a:rPr kumimoji="1" lang="en-US" altLang="ja-JP" dirty="0"/>
              <a:t> ITS region.</a:t>
            </a:r>
          </a:p>
          <a:p>
            <a:r>
              <a:rPr lang="en-US" altLang="ja-JP" dirty="0">
                <a:solidFill>
                  <a:srgbClr val="FF0000"/>
                </a:solidFill>
              </a:rPr>
              <a:t>The</a:t>
            </a:r>
            <a:r>
              <a:rPr lang="en-US" altLang="ja-JP" dirty="0"/>
              <a:t> ITS region, amplified </a:t>
            </a:r>
            <a:r>
              <a:rPr lang="en-US" altLang="ja-JP" dirty="0">
                <a:solidFill>
                  <a:srgbClr val="FF0000"/>
                </a:solidFill>
              </a:rPr>
              <a:t>using the </a:t>
            </a:r>
            <a:r>
              <a:rPr lang="en-US" altLang="ja-JP" dirty="0"/>
              <a:t>ITS-F and ITS-R primers, is suitable for PCR-RFLP and </a:t>
            </a:r>
            <a:r>
              <a:rPr lang="en-US" altLang="ja-JP" dirty="0">
                <a:solidFill>
                  <a:srgbClr val="FF0000"/>
                </a:solidFill>
              </a:rPr>
              <a:t>S</a:t>
            </a:r>
            <a:r>
              <a:rPr lang="en-US" altLang="ja-JP" dirty="0"/>
              <a:t>anger sequenc</a:t>
            </a:r>
            <a:r>
              <a:rPr lang="en-US" altLang="ja-JP" dirty="0">
                <a:solidFill>
                  <a:srgbClr val="FF0000"/>
                </a:solidFill>
              </a:rPr>
              <a:t>ing</a:t>
            </a:r>
            <a:r>
              <a:rPr lang="en-US" altLang="ja-JP" dirty="0"/>
              <a:t>.</a:t>
            </a:r>
          </a:p>
          <a:p>
            <a:r>
              <a:rPr lang="en-US" altLang="ja-JP" dirty="0">
                <a:solidFill>
                  <a:srgbClr val="FF0000"/>
                </a:solidFill>
              </a:rPr>
              <a:t>However, as the</a:t>
            </a:r>
            <a:r>
              <a:rPr kumimoji="1" lang="en-US" altLang="ja-JP" dirty="0">
                <a:solidFill>
                  <a:srgbClr val="FF0000"/>
                </a:solidFill>
              </a:rPr>
              <a:t> </a:t>
            </a:r>
            <a:r>
              <a:rPr kumimoji="1" lang="en-US" altLang="ja-JP" dirty="0"/>
              <a:t>amplified ITS region is </a:t>
            </a:r>
            <a:r>
              <a:rPr lang="en-US" altLang="ja-JP" dirty="0"/>
              <a:t>app</a:t>
            </a:r>
            <a:r>
              <a:rPr lang="en-US" altLang="ja-JP" dirty="0">
                <a:solidFill>
                  <a:srgbClr val="FF0000"/>
                </a:solidFill>
              </a:rPr>
              <a:t>rox</a:t>
            </a:r>
            <a:r>
              <a:rPr lang="en-US" altLang="ja-JP" dirty="0"/>
              <a:t>. 900 bp long, </a:t>
            </a:r>
            <a:r>
              <a:rPr lang="en-US" altLang="ja-JP" dirty="0">
                <a:solidFill>
                  <a:srgbClr val="FF0000"/>
                </a:solidFill>
              </a:rPr>
              <a:t>it is </a:t>
            </a:r>
            <a:r>
              <a:rPr lang="en-US" altLang="ja-JP" dirty="0"/>
              <a:t>not suitable for shotgun amplicon sequenc</a:t>
            </a:r>
            <a:r>
              <a:rPr lang="en-US" altLang="ja-JP" dirty="0">
                <a:solidFill>
                  <a:srgbClr val="FF0000"/>
                </a:solidFill>
              </a:rPr>
              <a:t>ing</a:t>
            </a:r>
            <a:r>
              <a:rPr lang="en-US" altLang="ja-JP" dirty="0"/>
              <a:t>. Therefore, primer</a:t>
            </a:r>
            <a:r>
              <a:rPr lang="en-US" altLang="ja-JP" dirty="0">
                <a:solidFill>
                  <a:srgbClr val="FF0000"/>
                </a:solidFill>
              </a:rPr>
              <a:t>s were </a:t>
            </a:r>
            <a:r>
              <a:rPr lang="en-US" altLang="ja-JP" dirty="0"/>
              <a:t>designed </a:t>
            </a:r>
            <a:r>
              <a:rPr lang="en-US" altLang="ja-JP" dirty="0">
                <a:solidFill>
                  <a:srgbClr val="FF0000"/>
                </a:solidFill>
              </a:rPr>
              <a:t>from the </a:t>
            </a:r>
            <a:r>
              <a:rPr lang="en-US" altLang="ja-JP" dirty="0"/>
              <a:t>tRNA-Ala </a:t>
            </a:r>
            <a:r>
              <a:rPr kumimoji="1" lang="en-US" altLang="ja-JP" dirty="0"/>
              <a:t>site. </a:t>
            </a:r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3A2675E-BEE0-5D7B-9B67-6B44A82DD4AB}"/>
              </a:ext>
            </a:extLst>
          </p:cNvPr>
          <p:cNvSpPr txBox="1"/>
          <p:nvPr/>
        </p:nvSpPr>
        <p:spPr>
          <a:xfrm>
            <a:off x="3278610" y="3679229"/>
            <a:ext cx="2674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i5 index sequence(8bp)</a:t>
            </a:r>
            <a:endParaRPr kumimoji="1"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6FC5571-0D5F-FE5D-81FC-9222C2C8D4E3}"/>
              </a:ext>
            </a:extLst>
          </p:cNvPr>
          <p:cNvSpPr txBox="1"/>
          <p:nvPr/>
        </p:nvSpPr>
        <p:spPr>
          <a:xfrm>
            <a:off x="1391919" y="3985897"/>
            <a:ext cx="3382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dapter sequence for Illumina</a:t>
            </a:r>
            <a:endParaRPr kumimoji="1" lang="ja-JP" altLang="en-US" dirty="0"/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034EB2B5-1494-2A88-9CAE-E5F520C77179}"/>
              </a:ext>
            </a:extLst>
          </p:cNvPr>
          <p:cNvCxnSpPr>
            <a:cxnSpLocks/>
          </p:cNvCxnSpPr>
          <p:nvPr/>
        </p:nvCxnSpPr>
        <p:spPr>
          <a:xfrm flipV="1">
            <a:off x="2944861" y="3152412"/>
            <a:ext cx="853027" cy="7854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7D838330-8E28-7B83-744D-CFAAA5D48122}"/>
              </a:ext>
            </a:extLst>
          </p:cNvPr>
          <p:cNvCxnSpPr>
            <a:cxnSpLocks/>
          </p:cNvCxnSpPr>
          <p:nvPr/>
        </p:nvCxnSpPr>
        <p:spPr>
          <a:xfrm flipV="1">
            <a:off x="4098664" y="2989471"/>
            <a:ext cx="371378" cy="6345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39E57662-9354-E03D-393D-4074CC9E354C}"/>
              </a:ext>
            </a:extLst>
          </p:cNvPr>
          <p:cNvCxnSpPr>
            <a:cxnSpLocks/>
          </p:cNvCxnSpPr>
          <p:nvPr/>
        </p:nvCxnSpPr>
        <p:spPr>
          <a:xfrm flipH="1" flipV="1">
            <a:off x="5187960" y="2917756"/>
            <a:ext cx="272560" cy="2046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BAA6BEF-E6D0-C43D-7E88-84D4774EA6A5}"/>
              </a:ext>
            </a:extLst>
          </p:cNvPr>
          <p:cNvSpPr txBox="1"/>
          <p:nvPr/>
        </p:nvSpPr>
        <p:spPr>
          <a:xfrm>
            <a:off x="4473586" y="3077669"/>
            <a:ext cx="21852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pecific sequence </a:t>
            </a:r>
          </a:p>
          <a:p>
            <a:r>
              <a:rPr kumimoji="1" lang="en-US" altLang="ja-JP" dirty="0"/>
              <a:t>for tRNA-Ala</a:t>
            </a:r>
            <a:endParaRPr kumimoji="1" lang="ja-JP" altLang="en-US" dirty="0"/>
          </a:p>
        </p:txBody>
      </p: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E54DD7BE-56A0-F79A-D834-D42BCAF4C064}"/>
              </a:ext>
            </a:extLst>
          </p:cNvPr>
          <p:cNvCxnSpPr>
            <a:cxnSpLocks/>
          </p:cNvCxnSpPr>
          <p:nvPr/>
        </p:nvCxnSpPr>
        <p:spPr>
          <a:xfrm flipV="1">
            <a:off x="7772305" y="2914873"/>
            <a:ext cx="239091" cy="3053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5EA5498-3B43-8B5E-1252-493AAE7568A2}"/>
              </a:ext>
            </a:extLst>
          </p:cNvPr>
          <p:cNvSpPr txBox="1"/>
          <p:nvPr/>
        </p:nvSpPr>
        <p:spPr>
          <a:xfrm>
            <a:off x="6781602" y="3145577"/>
            <a:ext cx="21852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pecific sequence </a:t>
            </a:r>
          </a:p>
          <a:p>
            <a:r>
              <a:rPr kumimoji="1" lang="en-US" altLang="ja-JP" dirty="0"/>
              <a:t>for 23S RNA</a:t>
            </a:r>
            <a:endParaRPr kumimoji="1" lang="ja-JP" altLang="en-US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A3F16A0-7C82-7748-7512-7683463F40C1}"/>
              </a:ext>
            </a:extLst>
          </p:cNvPr>
          <p:cNvSpPr txBox="1"/>
          <p:nvPr/>
        </p:nvSpPr>
        <p:spPr>
          <a:xfrm>
            <a:off x="7268309" y="3762601"/>
            <a:ext cx="2805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i7 index sequence (8 bp)</a:t>
            </a:r>
            <a:endParaRPr kumimoji="1" lang="ja-JP" altLang="en-US" dirty="0"/>
          </a:p>
        </p:txBody>
      </p: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34265EB7-169B-372E-1C77-DDECA0CF4412}"/>
              </a:ext>
            </a:extLst>
          </p:cNvPr>
          <p:cNvCxnSpPr>
            <a:cxnSpLocks/>
          </p:cNvCxnSpPr>
          <p:nvPr/>
        </p:nvCxnSpPr>
        <p:spPr>
          <a:xfrm flipH="1" flipV="1">
            <a:off x="8609433" y="2911184"/>
            <a:ext cx="522434" cy="85824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B944BF3-D54F-A482-B702-A510B3C79ADE}"/>
              </a:ext>
            </a:extLst>
          </p:cNvPr>
          <p:cNvSpPr txBox="1"/>
          <p:nvPr/>
        </p:nvSpPr>
        <p:spPr>
          <a:xfrm>
            <a:off x="8570423" y="4095823"/>
            <a:ext cx="3382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dapter sequence for Illumina</a:t>
            </a:r>
            <a:endParaRPr kumimoji="1" lang="ja-JP" altLang="en-US" dirty="0"/>
          </a:p>
        </p:txBody>
      </p:sp>
      <p:cxnSp>
        <p:nvCxnSpPr>
          <p:cNvPr id="53" name="直線矢印コネクタ 52">
            <a:extLst>
              <a:ext uri="{FF2B5EF4-FFF2-40B4-BE49-F238E27FC236}">
                <a16:creationId xmlns:a16="http://schemas.microsoft.com/office/drawing/2014/main" id="{195F9118-45A9-1BC4-985B-58C729F1C982}"/>
              </a:ext>
            </a:extLst>
          </p:cNvPr>
          <p:cNvCxnSpPr>
            <a:cxnSpLocks/>
            <a:stCxn id="52" idx="0"/>
          </p:cNvCxnSpPr>
          <p:nvPr/>
        </p:nvCxnSpPr>
        <p:spPr>
          <a:xfrm flipH="1" flipV="1">
            <a:off x="9227892" y="3083959"/>
            <a:ext cx="1033860" cy="101186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87235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94</TotalTime>
  <Words>335</Words>
  <Application>Microsoft Office PowerPoint</Application>
  <PresentationFormat>ワイド画面</PresentationFormat>
  <Paragraphs>64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寺石</dc:creator>
  <cp:lastModifiedBy>Author</cp:lastModifiedBy>
  <cp:revision>9</cp:revision>
  <cp:lastPrinted>2024-09-18T01:33:04Z</cp:lastPrinted>
  <dcterms:created xsi:type="dcterms:W3CDTF">2023-08-01T04:31:13Z</dcterms:created>
  <dcterms:modified xsi:type="dcterms:W3CDTF">2024-10-03T06:58:42Z</dcterms:modified>
</cp:coreProperties>
</file>